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424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8" autoAdjust="0"/>
    <p:restoredTop sz="94660"/>
  </p:normalViewPr>
  <p:slideViewPr>
    <p:cSldViewPr snapToGrid="0">
      <p:cViewPr varScale="1">
        <p:scale>
          <a:sx n="98" d="100"/>
          <a:sy n="98" d="100"/>
        </p:scale>
        <p:origin x="524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wangyarong\Desktop\&#32769;&#33635;\03%20MYBTT\04%20&#20114;&#20316;\&#21452;&#33639;&#20809;&#32032;&#37238;\&#26816;&#27979;&#32467;&#26524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8330927384076996E-2"/>
          <c:y val="0.12962962962962962"/>
          <c:w val="0.88389129483814521"/>
          <c:h val="0.6645902595508894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总表 副本'!$I$3</c:f>
              <c:strCache>
                <c:ptCount val="1"/>
                <c:pt idx="0">
                  <c:v>pSAK778+pGreenII0800-Pro</c:v>
                </c:pt>
              </c:strCache>
            </c:strRef>
          </c:tx>
          <c:spPr>
            <a:solidFill>
              <a:srgbClr val="90639F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总表 副本'!$I$17:$I$21</c:f>
                <c:numCache>
                  <c:formatCode>General</c:formatCode>
                  <c:ptCount val="5"/>
                  <c:pt idx="0">
                    <c:v>2.0616222660236192E-2</c:v>
                  </c:pt>
                  <c:pt idx="1">
                    <c:v>9.7966117712006053E-4</c:v>
                  </c:pt>
                  <c:pt idx="2">
                    <c:v>6.4708925653348525E-3</c:v>
                  </c:pt>
                  <c:pt idx="3">
                    <c:v>4.9604903408100613E-3</c:v>
                  </c:pt>
                  <c:pt idx="4">
                    <c:v>7.2094602896311238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总表 副本'!$H$4:$H$8</c:f>
              <c:strCache>
                <c:ptCount val="5"/>
                <c:pt idx="0">
                  <c:v>ANR2</c:v>
                </c:pt>
                <c:pt idx="1">
                  <c:v>LAR1</c:v>
                </c:pt>
                <c:pt idx="2">
                  <c:v>LAR2</c:v>
                </c:pt>
                <c:pt idx="3">
                  <c:v>ANS1</c:v>
                </c:pt>
                <c:pt idx="4">
                  <c:v>ANS2</c:v>
                </c:pt>
              </c:strCache>
            </c:strRef>
          </c:cat>
          <c:val>
            <c:numRef>
              <c:f>'总表 副本'!$I$4:$I$8</c:f>
              <c:numCache>
                <c:formatCode>General</c:formatCode>
                <c:ptCount val="5"/>
                <c:pt idx="0">
                  <c:v>1.2079778283181136E-2</c:v>
                </c:pt>
                <c:pt idx="1">
                  <c:v>9.5505446668609807E-3</c:v>
                </c:pt>
                <c:pt idx="2">
                  <c:v>9.7226003458715845E-3</c:v>
                </c:pt>
                <c:pt idx="3">
                  <c:v>7.9430931148060224E-3</c:v>
                </c:pt>
                <c:pt idx="4">
                  <c:v>1.1445774940554229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DF9-49EE-8094-FFA086A5FD02}"/>
            </c:ext>
          </c:extLst>
        </c:ser>
        <c:ser>
          <c:idx val="1"/>
          <c:order val="1"/>
          <c:tx>
            <c:strRef>
              <c:f>'总表 副本'!$J$3</c:f>
              <c:strCache>
                <c:ptCount val="1"/>
                <c:pt idx="0">
                  <c:v>pSAK778-mdmybtt+pGreenII0800-pro</c:v>
                </c:pt>
              </c:strCache>
            </c:strRef>
          </c:tx>
          <c:spPr>
            <a:solidFill>
              <a:srgbClr val="9AB846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总表 副本'!$J$17:$J$21</c:f>
                <c:numCache>
                  <c:formatCode>General</c:formatCode>
                  <c:ptCount val="5"/>
                  <c:pt idx="0">
                    <c:v>3.1884510139055453E-2</c:v>
                  </c:pt>
                  <c:pt idx="1">
                    <c:v>4.9266603625442058E-4</c:v>
                  </c:pt>
                  <c:pt idx="2">
                    <c:v>7.5822989707869833E-3</c:v>
                  </c:pt>
                  <c:pt idx="3">
                    <c:v>1.3129542188200021E-2</c:v>
                  </c:pt>
                  <c:pt idx="4">
                    <c:v>3.7381991579001845E-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总表 副本'!$H$4:$H$8</c:f>
              <c:strCache>
                <c:ptCount val="5"/>
                <c:pt idx="0">
                  <c:v>ANR2</c:v>
                </c:pt>
                <c:pt idx="1">
                  <c:v>LAR1</c:v>
                </c:pt>
                <c:pt idx="2">
                  <c:v>LAR2</c:v>
                </c:pt>
                <c:pt idx="3">
                  <c:v>ANS1</c:v>
                </c:pt>
                <c:pt idx="4">
                  <c:v>ANS2</c:v>
                </c:pt>
              </c:strCache>
            </c:strRef>
          </c:cat>
          <c:val>
            <c:numRef>
              <c:f>'总表 副本'!$J$4:$J$8</c:f>
              <c:numCache>
                <c:formatCode>General</c:formatCode>
                <c:ptCount val="5"/>
                <c:pt idx="0">
                  <c:v>1.7724208507989905E-2</c:v>
                </c:pt>
                <c:pt idx="1">
                  <c:v>1.1717230412533088E-2</c:v>
                </c:pt>
                <c:pt idx="2">
                  <c:v>9.6227911492292525E-3</c:v>
                </c:pt>
                <c:pt idx="3">
                  <c:v>1.4590844826763498E-2</c:v>
                </c:pt>
                <c:pt idx="4">
                  <c:v>1.3916834579519713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DF9-49EE-8094-FFA086A5FD02}"/>
            </c:ext>
          </c:extLst>
        </c:ser>
        <c:ser>
          <c:idx val="2"/>
          <c:order val="2"/>
          <c:tx>
            <c:strRef>
              <c:f>'总表 副本'!$K$3</c:f>
              <c:strCache>
                <c:ptCount val="1"/>
                <c:pt idx="0">
                  <c:v>pSAK778-MdMYBTT+pGreenII0800-pro</c:v>
                </c:pt>
              </c:strCache>
            </c:strRef>
          </c:tx>
          <c:spPr>
            <a:solidFill>
              <a:srgbClr val="DF5B3F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总表 副本'!$K$17:$K$21</c:f>
                <c:numCache>
                  <c:formatCode>General</c:formatCode>
                  <c:ptCount val="5"/>
                  <c:pt idx="0">
                    <c:v>7.1396997270145495E-3</c:v>
                  </c:pt>
                  <c:pt idx="1">
                    <c:v>1.2014241388214228E-2</c:v>
                  </c:pt>
                  <c:pt idx="2">
                    <c:v>0.11646151456865657</c:v>
                  </c:pt>
                  <c:pt idx="3">
                    <c:v>2.0443850298865637E-2</c:v>
                  </c:pt>
                  <c:pt idx="4">
                    <c:v>3.9329335922211717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0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总表 副本'!$H$4:$H$8</c:f>
              <c:strCache>
                <c:ptCount val="5"/>
                <c:pt idx="0">
                  <c:v>ANR2</c:v>
                </c:pt>
                <c:pt idx="1">
                  <c:v>LAR1</c:v>
                </c:pt>
                <c:pt idx="2">
                  <c:v>LAR2</c:v>
                </c:pt>
                <c:pt idx="3">
                  <c:v>ANS1</c:v>
                </c:pt>
                <c:pt idx="4">
                  <c:v>ANS2</c:v>
                </c:pt>
              </c:strCache>
            </c:strRef>
          </c:cat>
          <c:val>
            <c:numRef>
              <c:f>'总表 副本'!$K$4:$K$8</c:f>
              <c:numCache>
                <c:formatCode>General</c:formatCode>
                <c:ptCount val="5"/>
                <c:pt idx="0">
                  <c:v>1.1386049702841223E-2</c:v>
                </c:pt>
                <c:pt idx="1">
                  <c:v>4.203306581689107E-2</c:v>
                </c:pt>
                <c:pt idx="2">
                  <c:v>0.10522799059012192</c:v>
                </c:pt>
                <c:pt idx="3">
                  <c:v>2.4356011411472065E-2</c:v>
                </c:pt>
                <c:pt idx="4">
                  <c:v>4.4868483423276741E-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DF9-49EE-8094-FFA086A5FD0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51818944"/>
        <c:axId val="751819272"/>
      </c:barChart>
      <c:catAx>
        <c:axId val="7518189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>
              <a:defRPr lang="en-US" altLang="zh-CN" sz="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751819272"/>
        <c:crosses val="autoZero"/>
        <c:auto val="1"/>
        <c:lblAlgn val="ctr"/>
        <c:lblOffset val="100"/>
        <c:noMultiLvlLbl val="0"/>
      </c:catAx>
      <c:valAx>
        <c:axId val="7518192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 algn="ctr">
              <a:defRPr lang="en-US" altLang="zh-CN" sz="8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75181894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8.3514679142907527E-2"/>
          <c:y val="0.14160588526172227"/>
          <c:w val="0.63825072831522867"/>
          <c:h val="0.3113436862058908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lang="en-US" altLang="zh-CN" sz="800" b="0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zh-CN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35B1ED-F86F-4A3D-91B0-93F525F5E2CF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E29CFD8-7C1C-4BC9-A9F7-2D549B3ACB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139902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94151A5-B95F-4060-A5FC-F389C78CACF3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854795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581FCCB-F7A0-47AD-AC20-7C969675106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C32770C7-1181-4EBE-AB4F-34A034A60EC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949BC00-2C8E-4F9E-8DFC-AD3EFA0979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265B3CB-4DFD-4380-9E33-2D19558021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AB632F5-4004-43BE-A894-48AE73934D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49078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9100160-3FDC-44D0-9F62-277CA77C46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DD6F321-DC31-49E0-9A4A-9A631B70C03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8E83C318-0B67-410A-8C04-26BF21A40E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5BFE5AC-9838-4537-8264-C3CCD46198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525C987-EFEC-46DE-BC11-02CA116349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993364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97C7DCFA-689C-40BD-9587-38DD677E66C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0EF6F39-C995-4EF4-AEB1-21FD2E6E8C3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0547461-557A-4E09-856C-D537B58D86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C0B3021-015A-4A32-9262-E7D2F64400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A3F7901-7663-40B5-A438-AA35C1CB74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71925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2FABF3C-2C26-479B-B49D-1563166566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214D1EE-F4EB-45AF-B160-F4E14B9AF51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AC2F6C5-6B95-4C43-BD28-3948CB9129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6072172-9FE6-4C79-BA7E-D449435AF9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F1655CD-FB00-4867-8CC9-38EE57D6A4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624367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2D904A8-7140-4E15-ABC8-BCACA51AEE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9FE273F-F3BC-4EDA-95A7-287DEAD5A0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E34E2D2-2981-4C7A-BBD6-21BAD9FFD1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F92DAE7-75F6-46BC-9353-6AD3807A94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4969101-EBD7-419D-9D1A-0761C02F91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234040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AE40A1C-33C3-420A-BE99-561D7CB368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3428511-47B8-4435-BDBD-19796BCFC65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BB3B03E-269F-41C4-B194-26BC20D52A5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AFAE765-492A-4702-9F98-B5A0234652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76668DD-9BE5-4181-8236-17007EF08E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F212379-62ED-4F44-B90D-4A98EBE044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28152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AB82C16-2549-445F-BD14-00AC56AE5D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A59E935-FF0E-45DC-A42F-A0C23CE059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445E1EA-7914-47D5-AEC1-EDABAE649E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58731DD7-68F7-4EA0-9D34-8247DE5E874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9B66F667-0631-4AF0-AA34-78FBE3A81EE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1E6FFC3E-8156-49E8-BC5F-484077B5E5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18AD6E16-5809-4B02-879A-F014EE1E7D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EE640E36-B09A-4618-A27B-FF48F82BB0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148920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6033ABD-8856-47F0-AD8D-81B476E95F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DB638DD1-D36C-43EC-87E7-212A2F5605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B2AC69A6-522A-4D94-9C26-0FA9826639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1464667C-7B27-44B4-A899-E9754EABBD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50152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12F695B8-0299-4A81-A058-11D1C123E4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6FF9A398-FA1B-42B3-ABBE-CF2A33DA14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F461A4F-9387-473F-80EC-BB947A23F00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937976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EFA41EB-ADF1-4171-BA2E-F899D7E1D4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FA198B67-43A3-4908-9D87-7B8ED5B3E3C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565D3868-63DA-445C-959E-6A81AE18620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7628954-8310-429C-B879-0C39566619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5A5AB87-4358-4C34-A45D-EF19D0A0A6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CAEFFEE-FFCE-4767-BC57-900D0AEF22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696117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81C9578-790E-4EFC-AD7D-5D36B634956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B4CBD583-BC12-4947-B31C-1BE07F03A41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2FCEEDC9-0E30-4C91-BAC4-3F5E0985E1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0DD3960-C2F5-4B95-B4A7-AE986054618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86B8756-5B6D-4A90-A48F-2FCFD92B99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868163B7-88DA-4D9C-B1AB-1B7E8AB225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54643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901A57E7-A18D-43AF-87BE-53F6DC0D9B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202DFA5-BB78-4CA9-9DFC-E9447FA528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CEB0252-DAC6-4D3D-99B9-395345D5B10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A33762-B0FE-4CA0-9CB8-F76A1AE9E94E}" type="datetimeFigureOut">
              <a:rPr lang="zh-CN" altLang="en-US" smtClean="0"/>
              <a:t>2025/4/18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0DE0D05-08B2-46BF-91F3-5A6DA980641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19C1876-B017-4C34-BD68-5098EEA4571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50C87F-703A-48FF-B00A-A359906CF0A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714117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13" Type="http://schemas.openxmlformats.org/officeDocument/2006/relationships/image" Target="../media/image11.jpeg"/><Relationship Id="rId18" Type="http://schemas.openxmlformats.org/officeDocument/2006/relationships/image" Target="../media/image15.png"/><Relationship Id="rId3" Type="http://schemas.openxmlformats.org/officeDocument/2006/relationships/image" Target="../media/image1.jpeg"/><Relationship Id="rId7" Type="http://schemas.openxmlformats.org/officeDocument/2006/relationships/image" Target="../media/image5.jpeg"/><Relationship Id="rId12" Type="http://schemas.openxmlformats.org/officeDocument/2006/relationships/image" Target="../media/image10.jpeg"/><Relationship Id="rId17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png"/><Relationship Id="rId20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11" Type="http://schemas.openxmlformats.org/officeDocument/2006/relationships/image" Target="../media/image9.jpeg"/><Relationship Id="rId5" Type="http://schemas.openxmlformats.org/officeDocument/2006/relationships/image" Target="../media/image3.jpeg"/><Relationship Id="rId15" Type="http://schemas.openxmlformats.org/officeDocument/2006/relationships/image" Target="../media/image13.jpeg"/><Relationship Id="rId10" Type="http://schemas.openxmlformats.org/officeDocument/2006/relationships/image" Target="../media/image8.jpeg"/><Relationship Id="rId19" Type="http://schemas.openxmlformats.org/officeDocument/2006/relationships/image" Target="../media/image16.png"/><Relationship Id="rId4" Type="http://schemas.openxmlformats.org/officeDocument/2006/relationships/image" Target="../media/image2.png"/><Relationship Id="rId9" Type="http://schemas.openxmlformats.org/officeDocument/2006/relationships/image" Target="../media/image7.jpeg"/><Relationship Id="rId14" Type="http://schemas.openxmlformats.org/officeDocument/2006/relationships/image" Target="../media/image1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7BAAE041-7518-4E5F-B785-CD8DC8D3EF5A}"/>
              </a:ext>
            </a:extLst>
          </p:cNvPr>
          <p:cNvGrpSpPr/>
          <p:nvPr/>
        </p:nvGrpSpPr>
        <p:grpSpPr>
          <a:xfrm>
            <a:off x="2423662" y="1389573"/>
            <a:ext cx="6525865" cy="3895610"/>
            <a:chOff x="2183031" y="1403324"/>
            <a:chExt cx="6525865" cy="3895610"/>
          </a:xfrm>
        </p:grpSpPr>
        <p:pic>
          <p:nvPicPr>
            <p:cNvPr id="112" name="图片 111">
              <a:extLst>
                <a:ext uri="{FF2B5EF4-FFF2-40B4-BE49-F238E27FC236}">
                  <a16:creationId xmlns:a16="http://schemas.microsoft.com/office/drawing/2014/main" id="{49C93AD0-5C62-401E-8C60-4DFE2553D20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177" t="59868" r="28755" b="17163"/>
            <a:stretch/>
          </p:blipFill>
          <p:spPr>
            <a:xfrm>
              <a:off x="4546862" y="1823606"/>
              <a:ext cx="904562" cy="373660"/>
            </a:xfrm>
            <a:prstGeom prst="rect">
              <a:avLst/>
            </a:prstGeom>
          </p:spPr>
        </p:pic>
        <p:grpSp>
          <p:nvGrpSpPr>
            <p:cNvPr id="80" name="组合 79">
              <a:extLst>
                <a:ext uri="{FF2B5EF4-FFF2-40B4-BE49-F238E27FC236}">
                  <a16:creationId xmlns:a16="http://schemas.microsoft.com/office/drawing/2014/main" id="{CBECD891-BF78-46BE-9E75-3D90DD49AAD1}"/>
                </a:ext>
              </a:extLst>
            </p:cNvPr>
            <p:cNvGrpSpPr/>
            <p:nvPr/>
          </p:nvGrpSpPr>
          <p:grpSpPr>
            <a:xfrm>
              <a:off x="7652921" y="2405744"/>
              <a:ext cx="1055975" cy="933538"/>
              <a:chOff x="9317957" y="1735380"/>
              <a:chExt cx="1539745" cy="1344887"/>
            </a:xfrm>
          </p:grpSpPr>
          <p:pic>
            <p:nvPicPr>
              <p:cNvPr id="34" name="图片 33">
                <a:extLst>
                  <a:ext uri="{FF2B5EF4-FFF2-40B4-BE49-F238E27FC236}">
                    <a16:creationId xmlns:a16="http://schemas.microsoft.com/office/drawing/2014/main" id="{DDAB04A1-B8D3-4492-9EF3-FBD3A716F77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7231" t="24325" r="14750" b="16158"/>
              <a:stretch/>
            </p:blipFill>
            <p:spPr>
              <a:xfrm>
                <a:off x="9317957" y="1829332"/>
                <a:ext cx="1090075" cy="1169285"/>
              </a:xfrm>
              <a:prstGeom prst="rect">
                <a:avLst/>
              </a:prstGeom>
            </p:spPr>
          </p:pic>
          <p:sp>
            <p:nvSpPr>
              <p:cNvPr id="115" name="文本框 114">
                <a:extLst>
                  <a:ext uri="{FF2B5EF4-FFF2-40B4-BE49-F238E27FC236}">
                    <a16:creationId xmlns:a16="http://schemas.microsoft.com/office/drawing/2014/main" id="{EEC23883-11AD-4EA2-BFC3-695444D691D9}"/>
                  </a:ext>
                </a:extLst>
              </p:cNvPr>
              <p:cNvSpPr txBox="1"/>
              <p:nvPr/>
            </p:nvSpPr>
            <p:spPr>
              <a:xfrm>
                <a:off x="9522717" y="2723940"/>
                <a:ext cx="1178146" cy="3103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NS2Pro</a:t>
                </a:r>
                <a:endParaRPr lang="zh-CN" altLang="en-US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7" name="矩形 196">
                <a:extLst>
                  <a:ext uri="{FF2B5EF4-FFF2-40B4-BE49-F238E27FC236}">
                    <a16:creationId xmlns:a16="http://schemas.microsoft.com/office/drawing/2014/main" id="{3F7B9E5C-87B6-4930-AC97-C9C8DAA1712C}"/>
                  </a:ext>
                </a:extLst>
              </p:cNvPr>
              <p:cNvSpPr/>
              <p:nvPr/>
            </p:nvSpPr>
            <p:spPr>
              <a:xfrm>
                <a:off x="10408033" y="1829332"/>
                <a:ext cx="209993" cy="1169285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/>
              </a:p>
            </p:txBody>
          </p:sp>
          <p:sp>
            <p:nvSpPr>
              <p:cNvPr id="198" name="矩形 197">
                <a:extLst>
                  <a:ext uri="{FF2B5EF4-FFF2-40B4-BE49-F238E27FC236}">
                    <a16:creationId xmlns:a16="http://schemas.microsoft.com/office/drawing/2014/main" id="{F13352FD-8CD0-42D0-9323-F44FB6A226AD}"/>
                  </a:ext>
                </a:extLst>
              </p:cNvPr>
              <p:cNvSpPr/>
              <p:nvPr/>
            </p:nvSpPr>
            <p:spPr>
              <a:xfrm>
                <a:off x="10435822" y="1935988"/>
                <a:ext cx="94040" cy="946509"/>
              </a:xfrm>
              <a:prstGeom prst="rect">
                <a:avLst/>
              </a:prstGeom>
              <a:gradFill>
                <a:gsLst>
                  <a:gs pos="0">
                    <a:srgbClr val="FF0900"/>
                  </a:gs>
                  <a:gs pos="31471">
                    <a:srgbClr val="FFFF00"/>
                  </a:gs>
                  <a:gs pos="22000">
                    <a:srgbClr val="FFEC00"/>
                  </a:gs>
                  <a:gs pos="65000">
                    <a:srgbClr val="00F3FF"/>
                  </a:gs>
                  <a:gs pos="84000">
                    <a:srgbClr val="0000E0"/>
                  </a:gs>
                  <a:gs pos="47188">
                    <a:srgbClr val="00FF29"/>
                  </a:gs>
                  <a:gs pos="100000">
                    <a:schemeClr val="tx1"/>
                  </a:gs>
                </a:gsLst>
                <a:lin ang="5400000" scaled="0"/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/>
              </a:p>
            </p:txBody>
          </p:sp>
          <p:sp>
            <p:nvSpPr>
              <p:cNvPr id="199" name="文本框 198">
                <a:extLst>
                  <a:ext uri="{FF2B5EF4-FFF2-40B4-BE49-F238E27FC236}">
                    <a16:creationId xmlns:a16="http://schemas.microsoft.com/office/drawing/2014/main" id="{8FE8B9FC-E07A-428E-B48F-2522176B7E6D}"/>
                  </a:ext>
                </a:extLst>
              </p:cNvPr>
              <p:cNvSpPr txBox="1"/>
              <p:nvPr/>
            </p:nvSpPr>
            <p:spPr>
              <a:xfrm>
                <a:off x="10158187" y="2769891"/>
                <a:ext cx="632436" cy="3103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711</a:t>
                </a:r>
                <a:endParaRPr lang="zh-CN" altLang="en-US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00" name="文本框 199">
                <a:extLst>
                  <a:ext uri="{FF2B5EF4-FFF2-40B4-BE49-F238E27FC236}">
                    <a16:creationId xmlns:a16="http://schemas.microsoft.com/office/drawing/2014/main" id="{F287AF9F-98E9-4FEF-9049-D05C54C5B255}"/>
                  </a:ext>
                </a:extLst>
              </p:cNvPr>
              <p:cNvSpPr txBox="1"/>
              <p:nvPr/>
            </p:nvSpPr>
            <p:spPr>
              <a:xfrm>
                <a:off x="10168356" y="1735380"/>
                <a:ext cx="689346" cy="31037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791</a:t>
                </a:r>
                <a:endParaRPr lang="zh-CN" altLang="en-US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pic>
          <p:nvPicPr>
            <p:cNvPr id="3" name="图片 2">
              <a:extLst>
                <a:ext uri="{FF2B5EF4-FFF2-40B4-BE49-F238E27FC236}">
                  <a16:creationId xmlns:a16="http://schemas.microsoft.com/office/drawing/2014/main" id="{CDAF0BA3-C230-4285-928C-F810E72DF3F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068" t="28936" r="31339" b="42039"/>
            <a:stretch/>
          </p:blipFill>
          <p:spPr>
            <a:xfrm>
              <a:off x="3570880" y="3309294"/>
              <a:ext cx="913732" cy="538291"/>
            </a:xfrm>
            <a:prstGeom prst="rect">
              <a:avLst/>
            </a:prstGeom>
          </p:spPr>
        </p:pic>
        <p:pic>
          <p:nvPicPr>
            <p:cNvPr id="15" name="图片 14">
              <a:extLst>
                <a:ext uri="{FF2B5EF4-FFF2-40B4-BE49-F238E27FC236}">
                  <a16:creationId xmlns:a16="http://schemas.microsoft.com/office/drawing/2014/main" id="{B66FCB9D-A03C-4A51-8318-0674C56603D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418" t="33041" r="32891" b="36241"/>
            <a:stretch/>
          </p:blipFill>
          <p:spPr>
            <a:xfrm>
              <a:off x="3570880" y="2214174"/>
              <a:ext cx="913731" cy="534323"/>
            </a:xfrm>
            <a:prstGeom prst="rect">
              <a:avLst/>
            </a:prstGeom>
          </p:spPr>
        </p:pic>
        <p:pic>
          <p:nvPicPr>
            <p:cNvPr id="19" name="图片 18">
              <a:extLst>
                <a:ext uri="{FF2B5EF4-FFF2-40B4-BE49-F238E27FC236}">
                  <a16:creationId xmlns:a16="http://schemas.microsoft.com/office/drawing/2014/main" id="{B242110C-7EA6-4C76-9B59-DBC62DDEF35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151" t="28369" r="35059" b="41759"/>
            <a:stretch/>
          </p:blipFill>
          <p:spPr>
            <a:xfrm>
              <a:off x="4546862" y="2214174"/>
              <a:ext cx="904562" cy="536501"/>
            </a:xfrm>
            <a:prstGeom prst="rect">
              <a:avLst/>
            </a:prstGeom>
          </p:spPr>
        </p:pic>
        <p:pic>
          <p:nvPicPr>
            <p:cNvPr id="21" name="图片 20">
              <a:extLst>
                <a:ext uri="{FF2B5EF4-FFF2-40B4-BE49-F238E27FC236}">
                  <a16:creationId xmlns:a16="http://schemas.microsoft.com/office/drawing/2014/main" id="{B78BB175-D336-41F5-8D7E-B80393B8DA6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635" t="30071" r="30268" b="40798"/>
            <a:stretch/>
          </p:blipFill>
          <p:spPr>
            <a:xfrm>
              <a:off x="3570880" y="3865440"/>
              <a:ext cx="913731" cy="518255"/>
            </a:xfrm>
            <a:prstGeom prst="rect">
              <a:avLst/>
            </a:prstGeom>
          </p:spPr>
        </p:pic>
        <p:pic>
          <p:nvPicPr>
            <p:cNvPr id="25" name="图片 24">
              <a:extLst>
                <a:ext uri="{FF2B5EF4-FFF2-40B4-BE49-F238E27FC236}">
                  <a16:creationId xmlns:a16="http://schemas.microsoft.com/office/drawing/2014/main" id="{D2ACF65C-76CE-45D2-8E07-1F5BD70BA5A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177" t="27611" r="28755" b="39544"/>
            <a:stretch/>
          </p:blipFill>
          <p:spPr>
            <a:xfrm>
              <a:off x="4549941" y="3865440"/>
              <a:ext cx="901483" cy="518255"/>
            </a:xfrm>
            <a:prstGeom prst="rect">
              <a:avLst/>
            </a:prstGeom>
          </p:spPr>
        </p:pic>
        <p:pic>
          <p:nvPicPr>
            <p:cNvPr id="27" name="图片 26">
              <a:extLst>
                <a:ext uri="{FF2B5EF4-FFF2-40B4-BE49-F238E27FC236}">
                  <a16:creationId xmlns:a16="http://schemas.microsoft.com/office/drawing/2014/main" id="{EC95BF52-8FE4-46F9-8825-7FAFB445ACF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176" t="23641" r="30017" b="43062"/>
            <a:stretch/>
          </p:blipFill>
          <p:spPr>
            <a:xfrm>
              <a:off x="3570880" y="4405257"/>
              <a:ext cx="913731" cy="529187"/>
            </a:xfrm>
            <a:prstGeom prst="rect">
              <a:avLst/>
            </a:prstGeom>
          </p:spPr>
        </p:pic>
        <p:pic>
          <p:nvPicPr>
            <p:cNvPr id="29" name="图片 28">
              <a:extLst>
                <a:ext uri="{FF2B5EF4-FFF2-40B4-BE49-F238E27FC236}">
                  <a16:creationId xmlns:a16="http://schemas.microsoft.com/office/drawing/2014/main" id="{79106889-B90F-4BE6-AF36-8655B94849B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9007" t="25342" r="34051" b="40740"/>
            <a:stretch/>
          </p:blipFill>
          <p:spPr>
            <a:xfrm>
              <a:off x="4549941" y="4405257"/>
              <a:ext cx="901483" cy="529186"/>
            </a:xfrm>
            <a:prstGeom prst="rect">
              <a:avLst/>
            </a:prstGeom>
          </p:spPr>
        </p:pic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A8815568-E8B6-4036-94A4-AE520CDA182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40246" y="3661373"/>
              <a:ext cx="1442855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9pPr>
            </a:lstStyle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D-</a:t>
              </a:r>
              <a:r>
                <a:rPr lang="en-US" altLang="zh-CN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dMYBTT</a:t>
              </a:r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+LAR2-Pro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6F4DE0B6-47D4-4987-BF04-73546E33431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40246" y="3486255"/>
              <a:ext cx="128240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9pPr>
            </a:lstStyle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D-</a:t>
              </a:r>
              <a:r>
                <a:rPr lang="en-US" altLang="zh-CN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dmybtt</a:t>
              </a:r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+ LAR2-Pro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文本框 40">
              <a:extLst>
                <a:ext uri="{FF2B5EF4-FFF2-40B4-BE49-F238E27FC236}">
                  <a16:creationId xmlns:a16="http://schemas.microsoft.com/office/drawing/2014/main" id="{4174FF9A-674B-4B35-8A28-03C1BD77D0B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40246" y="3295673"/>
              <a:ext cx="128240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9pPr>
            </a:lstStyle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D + LAR2-Pro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文本框 46">
              <a:extLst>
                <a:ext uri="{FF2B5EF4-FFF2-40B4-BE49-F238E27FC236}">
                  <a16:creationId xmlns:a16="http://schemas.microsoft.com/office/drawing/2014/main" id="{E8DF3DCD-E26A-4C4B-835F-F8C9EF37A15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40246" y="2553688"/>
              <a:ext cx="1403345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9pPr>
            </a:lstStyle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D-</a:t>
              </a:r>
              <a:r>
                <a:rPr lang="en-US" altLang="zh-CN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dMYBTT</a:t>
              </a:r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+ANR2-Pro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0" name="文本框 49">
              <a:extLst>
                <a:ext uri="{FF2B5EF4-FFF2-40B4-BE49-F238E27FC236}">
                  <a16:creationId xmlns:a16="http://schemas.microsoft.com/office/drawing/2014/main" id="{4DA6933A-23C5-420E-BCE8-C2F78476224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40246" y="2368210"/>
              <a:ext cx="1361403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9pPr>
            </a:lstStyle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D-</a:t>
              </a:r>
              <a:r>
                <a:rPr lang="en-US" altLang="zh-CN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dmybtt</a:t>
              </a:r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+ ANR2-Pro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1" name="文本框 50">
              <a:extLst>
                <a:ext uri="{FF2B5EF4-FFF2-40B4-BE49-F238E27FC236}">
                  <a16:creationId xmlns:a16="http://schemas.microsoft.com/office/drawing/2014/main" id="{CB567C44-89C6-46B7-B7F4-516DD67D483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40246" y="2172643"/>
              <a:ext cx="128240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9pPr>
            </a:lstStyle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D + ANR2-Pro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" name="文本框 51">
              <a:extLst>
                <a:ext uri="{FF2B5EF4-FFF2-40B4-BE49-F238E27FC236}">
                  <a16:creationId xmlns:a16="http://schemas.microsoft.com/office/drawing/2014/main" id="{4EBE34B7-590C-450B-AC0C-8C915D7EF2E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40246" y="4769570"/>
              <a:ext cx="1403345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9pPr>
            </a:lstStyle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D-</a:t>
              </a:r>
              <a:r>
                <a:rPr lang="en-US" altLang="zh-CN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dMYBTT</a:t>
              </a:r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+ANS2-Pro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文本框 54">
              <a:extLst>
                <a:ext uri="{FF2B5EF4-FFF2-40B4-BE49-F238E27FC236}">
                  <a16:creationId xmlns:a16="http://schemas.microsoft.com/office/drawing/2014/main" id="{27CEF53C-EC93-4059-86EC-45A8B4D9F9B8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40246" y="4566477"/>
              <a:ext cx="128240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9pPr>
            </a:lstStyle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D-</a:t>
              </a:r>
              <a:r>
                <a:rPr lang="en-US" altLang="zh-CN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dmybtt</a:t>
              </a:r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+ ANS2-Pro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文本框 55">
              <a:extLst>
                <a:ext uri="{FF2B5EF4-FFF2-40B4-BE49-F238E27FC236}">
                  <a16:creationId xmlns:a16="http://schemas.microsoft.com/office/drawing/2014/main" id="{400C5C0F-F564-4ADB-AF6B-B7DA90224E2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40246" y="4393052"/>
              <a:ext cx="128240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9pPr>
            </a:lstStyle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D + ANS2-Pro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文本框 56">
              <a:extLst>
                <a:ext uri="{FF2B5EF4-FFF2-40B4-BE49-F238E27FC236}">
                  <a16:creationId xmlns:a16="http://schemas.microsoft.com/office/drawing/2014/main" id="{ABF24EC0-4126-4E90-8DE9-3162B22A178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40246" y="4173478"/>
              <a:ext cx="142659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9pPr>
            </a:lstStyle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D-</a:t>
              </a:r>
              <a:r>
                <a:rPr lang="en-US" altLang="zh-CN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dMYBTT</a:t>
              </a:r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+ANS1-Pro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文本框 57">
              <a:extLst>
                <a:ext uri="{FF2B5EF4-FFF2-40B4-BE49-F238E27FC236}">
                  <a16:creationId xmlns:a16="http://schemas.microsoft.com/office/drawing/2014/main" id="{7E9D6030-A6B0-4D7D-8BBF-BA8C36DE295C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40246" y="1765728"/>
              <a:ext cx="128240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9pPr>
            </a:lstStyle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D + p53-Pro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文本框 58">
              <a:extLst>
                <a:ext uri="{FF2B5EF4-FFF2-40B4-BE49-F238E27FC236}">
                  <a16:creationId xmlns:a16="http://schemas.microsoft.com/office/drawing/2014/main" id="{7E1E9D60-B177-454F-9A45-A55ED6FDA370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40246" y="1991496"/>
              <a:ext cx="128240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9pPr>
            </a:lstStyle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D-Rec-p53 + p53-Pro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文本框 59">
              <a:extLst>
                <a:ext uri="{FF2B5EF4-FFF2-40B4-BE49-F238E27FC236}">
                  <a16:creationId xmlns:a16="http://schemas.microsoft.com/office/drawing/2014/main" id="{7E69C70F-859B-4908-8FA1-EADAEC2806F9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40246" y="4016534"/>
              <a:ext cx="128240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9pPr>
            </a:lstStyle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D-</a:t>
              </a:r>
              <a:r>
                <a:rPr lang="en-US" altLang="zh-CN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dmybtt</a:t>
              </a:r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+ ANS1-Pro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文本框 60">
              <a:extLst>
                <a:ext uri="{FF2B5EF4-FFF2-40B4-BE49-F238E27FC236}">
                  <a16:creationId xmlns:a16="http://schemas.microsoft.com/office/drawing/2014/main" id="{5E1EFE4A-CD36-4527-8F26-75A6AABC281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40246" y="3843109"/>
              <a:ext cx="128240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9pPr>
            </a:lstStyle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D + ANS1-Pro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63" name="Group 5">
              <a:extLst>
                <a:ext uri="{FF2B5EF4-FFF2-40B4-BE49-F238E27FC236}">
                  <a16:creationId xmlns:a16="http://schemas.microsoft.com/office/drawing/2014/main" id="{F74D1ADD-CD79-4AC3-BE51-D56A930FA005}"/>
                </a:ext>
              </a:extLst>
            </p:cNvPr>
            <p:cNvGrpSpPr/>
            <p:nvPr/>
          </p:nvGrpSpPr>
          <p:grpSpPr>
            <a:xfrm>
              <a:off x="3574062" y="1605018"/>
              <a:ext cx="978652" cy="215444"/>
              <a:chOff x="5123934" y="351953"/>
              <a:chExt cx="2156393" cy="411110"/>
            </a:xfrm>
          </p:grpSpPr>
          <p:sp>
            <p:nvSpPr>
              <p:cNvPr id="70" name="TextBox 28">
                <a:extLst>
                  <a:ext uri="{FF2B5EF4-FFF2-40B4-BE49-F238E27FC236}">
                    <a16:creationId xmlns:a16="http://schemas.microsoft.com/office/drawing/2014/main" id="{93399E5C-22A3-4C58-94A1-CED2F29C7FF6}"/>
                  </a:ext>
                </a:extLst>
              </p:cNvPr>
              <p:cNvSpPr txBox="1"/>
              <p:nvPr/>
            </p:nvSpPr>
            <p:spPr>
              <a:xfrm>
                <a:off x="5123934" y="351953"/>
                <a:ext cx="470477" cy="411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8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</a:t>
                </a:r>
                <a:endParaRPr lang="en-NZ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1" name="TextBox 29">
                <a:extLst>
                  <a:ext uri="{FF2B5EF4-FFF2-40B4-BE49-F238E27FC236}">
                    <a16:creationId xmlns:a16="http://schemas.microsoft.com/office/drawing/2014/main" id="{36738204-188F-42D5-AF43-D3E21D17EC81}"/>
                  </a:ext>
                </a:extLst>
              </p:cNvPr>
              <p:cNvSpPr txBox="1"/>
              <p:nvPr/>
            </p:nvSpPr>
            <p:spPr>
              <a:xfrm>
                <a:off x="5534768" y="351953"/>
                <a:ext cx="534055" cy="411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i</a:t>
                </a:r>
              </a:p>
            </p:txBody>
          </p:sp>
          <p:sp>
            <p:nvSpPr>
              <p:cNvPr id="72" name="TextBox 30">
                <a:extLst>
                  <a:ext uri="{FF2B5EF4-FFF2-40B4-BE49-F238E27FC236}">
                    <a16:creationId xmlns:a16="http://schemas.microsoft.com/office/drawing/2014/main" id="{1AD52A99-FF32-47D9-8366-321D69C7894C}"/>
                  </a:ext>
                </a:extLst>
              </p:cNvPr>
              <p:cNvSpPr txBox="1"/>
              <p:nvPr/>
            </p:nvSpPr>
            <p:spPr>
              <a:xfrm>
                <a:off x="5945598" y="351953"/>
                <a:ext cx="597632" cy="411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ii</a:t>
                </a:r>
              </a:p>
            </p:txBody>
          </p:sp>
          <p:sp>
            <p:nvSpPr>
              <p:cNvPr id="73" name="TextBox 31">
                <a:extLst>
                  <a:ext uri="{FF2B5EF4-FFF2-40B4-BE49-F238E27FC236}">
                    <a16:creationId xmlns:a16="http://schemas.microsoft.com/office/drawing/2014/main" id="{9F224DA7-E9F6-47D1-A244-9ADF895D96EE}"/>
                  </a:ext>
                </a:extLst>
              </p:cNvPr>
              <p:cNvSpPr txBox="1"/>
              <p:nvPr/>
            </p:nvSpPr>
            <p:spPr>
              <a:xfrm>
                <a:off x="6351746" y="351953"/>
                <a:ext cx="583504" cy="411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v</a:t>
                </a:r>
              </a:p>
            </p:txBody>
          </p:sp>
          <p:sp>
            <p:nvSpPr>
              <p:cNvPr id="74" name="TextBox 32">
                <a:extLst>
                  <a:ext uri="{FF2B5EF4-FFF2-40B4-BE49-F238E27FC236}">
                    <a16:creationId xmlns:a16="http://schemas.microsoft.com/office/drawing/2014/main" id="{6506E6CF-F567-4619-BF5A-A4CCA1ADDE27}"/>
                  </a:ext>
                </a:extLst>
              </p:cNvPr>
              <p:cNvSpPr txBox="1"/>
              <p:nvPr/>
            </p:nvSpPr>
            <p:spPr>
              <a:xfrm>
                <a:off x="6760401" y="351953"/>
                <a:ext cx="519926" cy="411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8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</a:t>
                </a:r>
                <a:endParaRPr lang="en-NZ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65" name="TextBox 5">
              <a:extLst>
                <a:ext uri="{FF2B5EF4-FFF2-40B4-BE49-F238E27FC236}">
                  <a16:creationId xmlns:a16="http://schemas.microsoft.com/office/drawing/2014/main" id="{83D2DD41-A76F-47DF-8359-240A9532EA9C}"/>
                </a:ext>
              </a:extLst>
            </p:cNvPr>
            <p:cNvSpPr txBox="1"/>
            <p:nvPr/>
          </p:nvSpPr>
          <p:spPr>
            <a:xfrm>
              <a:off x="3698375" y="1403324"/>
              <a:ext cx="91008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D/-Leu-</a:t>
              </a:r>
              <a:r>
                <a:rPr lang="en-US" altLang="zh-CN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bA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TextBox 5">
              <a:extLst>
                <a:ext uri="{FF2B5EF4-FFF2-40B4-BE49-F238E27FC236}">
                  <a16:creationId xmlns:a16="http://schemas.microsoft.com/office/drawing/2014/main" id="{0603BE6C-776F-4085-BE81-4E4148691D1D}"/>
                </a:ext>
              </a:extLst>
            </p:cNvPr>
            <p:cNvSpPr txBox="1"/>
            <p:nvPr/>
          </p:nvSpPr>
          <p:spPr>
            <a:xfrm>
              <a:off x="2590399" y="1403324"/>
              <a:ext cx="65361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structs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84" name="Group 5">
              <a:extLst>
                <a:ext uri="{FF2B5EF4-FFF2-40B4-BE49-F238E27FC236}">
                  <a16:creationId xmlns:a16="http://schemas.microsoft.com/office/drawing/2014/main" id="{F61DA295-DA71-4960-9D77-91178DA0F5C4}"/>
                </a:ext>
              </a:extLst>
            </p:cNvPr>
            <p:cNvGrpSpPr/>
            <p:nvPr/>
          </p:nvGrpSpPr>
          <p:grpSpPr>
            <a:xfrm>
              <a:off x="4515795" y="1625863"/>
              <a:ext cx="948433" cy="220721"/>
              <a:chOff x="5180687" y="348944"/>
              <a:chExt cx="1916452" cy="380969"/>
            </a:xfrm>
          </p:grpSpPr>
          <p:sp>
            <p:nvSpPr>
              <p:cNvPr id="87" name="TextBox 28">
                <a:extLst>
                  <a:ext uri="{FF2B5EF4-FFF2-40B4-BE49-F238E27FC236}">
                    <a16:creationId xmlns:a16="http://schemas.microsoft.com/office/drawing/2014/main" id="{C7F7757E-C20F-4C90-B837-CA480EEC200F}"/>
                  </a:ext>
                </a:extLst>
              </p:cNvPr>
              <p:cNvSpPr txBox="1"/>
              <p:nvPr/>
            </p:nvSpPr>
            <p:spPr>
              <a:xfrm>
                <a:off x="5180687" y="358052"/>
                <a:ext cx="431449" cy="3718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8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</a:t>
                </a:r>
                <a:endParaRPr lang="en-NZ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8" name="TextBox 29">
                <a:extLst>
                  <a:ext uri="{FF2B5EF4-FFF2-40B4-BE49-F238E27FC236}">
                    <a16:creationId xmlns:a16="http://schemas.microsoft.com/office/drawing/2014/main" id="{2D79C6DE-51AA-47FE-A83D-0C9936D67B25}"/>
                  </a:ext>
                </a:extLst>
              </p:cNvPr>
              <p:cNvSpPr txBox="1"/>
              <p:nvPr/>
            </p:nvSpPr>
            <p:spPr>
              <a:xfrm>
                <a:off x="5534768" y="351952"/>
                <a:ext cx="489753" cy="3718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i</a:t>
                </a:r>
              </a:p>
            </p:txBody>
          </p:sp>
          <p:sp>
            <p:nvSpPr>
              <p:cNvPr id="89" name="TextBox 30">
                <a:extLst>
                  <a:ext uri="{FF2B5EF4-FFF2-40B4-BE49-F238E27FC236}">
                    <a16:creationId xmlns:a16="http://schemas.microsoft.com/office/drawing/2014/main" id="{C795FBE2-A84E-4203-9507-41F1A1D419FF}"/>
                  </a:ext>
                </a:extLst>
              </p:cNvPr>
              <p:cNvSpPr txBox="1"/>
              <p:nvPr/>
            </p:nvSpPr>
            <p:spPr>
              <a:xfrm>
                <a:off x="5890219" y="351467"/>
                <a:ext cx="548057" cy="3718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ii</a:t>
                </a:r>
              </a:p>
            </p:txBody>
          </p:sp>
          <p:sp>
            <p:nvSpPr>
              <p:cNvPr id="90" name="TextBox 31">
                <a:extLst>
                  <a:ext uri="{FF2B5EF4-FFF2-40B4-BE49-F238E27FC236}">
                    <a16:creationId xmlns:a16="http://schemas.microsoft.com/office/drawing/2014/main" id="{1E159A43-899B-43DA-9FAF-68B85FB349E8}"/>
                  </a:ext>
                </a:extLst>
              </p:cNvPr>
              <p:cNvSpPr txBox="1"/>
              <p:nvPr/>
            </p:nvSpPr>
            <p:spPr>
              <a:xfrm>
                <a:off x="6234673" y="351467"/>
                <a:ext cx="535101" cy="3718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v</a:t>
                </a:r>
              </a:p>
            </p:txBody>
          </p:sp>
          <p:sp>
            <p:nvSpPr>
              <p:cNvPr id="91" name="TextBox 32">
                <a:extLst>
                  <a:ext uri="{FF2B5EF4-FFF2-40B4-BE49-F238E27FC236}">
                    <a16:creationId xmlns:a16="http://schemas.microsoft.com/office/drawing/2014/main" id="{E4482E7B-A2D5-4937-B9EB-BFE184DA538A}"/>
                  </a:ext>
                </a:extLst>
              </p:cNvPr>
              <p:cNvSpPr txBox="1"/>
              <p:nvPr/>
            </p:nvSpPr>
            <p:spPr>
              <a:xfrm>
                <a:off x="6620342" y="348944"/>
                <a:ext cx="476797" cy="37186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NZ" sz="8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v</a:t>
                </a:r>
                <a:endParaRPr lang="en-NZ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cxnSp>
          <p:nvCxnSpPr>
            <p:cNvPr id="85" name="Straight Connector 50">
              <a:extLst>
                <a:ext uri="{FF2B5EF4-FFF2-40B4-BE49-F238E27FC236}">
                  <a16:creationId xmlns:a16="http://schemas.microsoft.com/office/drawing/2014/main" id="{37D8A0CA-5324-4903-91B6-D30521B64B6F}"/>
                </a:ext>
              </a:extLst>
            </p:cNvPr>
            <p:cNvCxnSpPr>
              <a:cxnSpLocks/>
            </p:cNvCxnSpPr>
            <p:nvPr/>
          </p:nvCxnSpPr>
          <p:spPr>
            <a:xfrm>
              <a:off x="4525545" y="1605659"/>
              <a:ext cx="91609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6" name="TextBox 5">
              <a:extLst>
                <a:ext uri="{FF2B5EF4-FFF2-40B4-BE49-F238E27FC236}">
                  <a16:creationId xmlns:a16="http://schemas.microsoft.com/office/drawing/2014/main" id="{3F31E4FF-9138-4E89-B318-D1BDECF1B719}"/>
                </a:ext>
              </a:extLst>
            </p:cNvPr>
            <p:cNvSpPr txBox="1"/>
            <p:nvPr/>
          </p:nvSpPr>
          <p:spPr>
            <a:xfrm>
              <a:off x="4547344" y="1403324"/>
              <a:ext cx="109968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D/-Leu+AbA</a:t>
              </a:r>
              <a:r>
                <a:rPr lang="en-US" altLang="zh-CN" sz="800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0ng/ml</a:t>
              </a:r>
              <a:endParaRPr lang="zh-CN" altLang="en-US" sz="800" baseline="30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4" name="图片 3">
              <a:extLst>
                <a:ext uri="{FF2B5EF4-FFF2-40B4-BE49-F238E27FC236}">
                  <a16:creationId xmlns:a16="http://schemas.microsoft.com/office/drawing/2014/main" id="{6E827272-8F3D-48F8-8593-FA74FA80D2B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648" t="30763" r="31245" b="36513"/>
            <a:stretch/>
          </p:blipFill>
          <p:spPr>
            <a:xfrm>
              <a:off x="4546865" y="3309294"/>
              <a:ext cx="904559" cy="534323"/>
            </a:xfrm>
            <a:prstGeom prst="rect">
              <a:avLst/>
            </a:prstGeom>
          </p:spPr>
        </p:pic>
        <p:pic>
          <p:nvPicPr>
            <p:cNvPr id="81" name="图片 80">
              <a:extLst>
                <a:ext uri="{FF2B5EF4-FFF2-40B4-BE49-F238E27FC236}">
                  <a16:creationId xmlns:a16="http://schemas.microsoft.com/office/drawing/2014/main" id="{D9956F3E-4C35-4222-8512-DF5CF8CE44A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4058" t="34684" r="33437" b="23692"/>
            <a:stretch/>
          </p:blipFill>
          <p:spPr>
            <a:xfrm>
              <a:off x="3570880" y="2770878"/>
              <a:ext cx="913731" cy="517413"/>
            </a:xfrm>
            <a:prstGeom prst="rect">
              <a:avLst/>
            </a:prstGeom>
          </p:spPr>
        </p:pic>
        <p:pic>
          <p:nvPicPr>
            <p:cNvPr id="82" name="图片 81">
              <a:extLst>
                <a:ext uri="{FF2B5EF4-FFF2-40B4-BE49-F238E27FC236}">
                  <a16:creationId xmlns:a16="http://schemas.microsoft.com/office/drawing/2014/main" id="{F5893F7B-1E86-4294-BC00-390D4896A0A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775" t="13041" r="35934" b="33526"/>
            <a:stretch/>
          </p:blipFill>
          <p:spPr>
            <a:xfrm rot="16200000">
              <a:off x="4740439" y="2577306"/>
              <a:ext cx="517412" cy="904558"/>
            </a:xfrm>
            <a:prstGeom prst="rect">
              <a:avLst/>
            </a:prstGeom>
          </p:spPr>
        </p:pic>
        <p:sp>
          <p:nvSpPr>
            <p:cNvPr id="113" name="文本框 112">
              <a:extLst>
                <a:ext uri="{FF2B5EF4-FFF2-40B4-BE49-F238E27FC236}">
                  <a16:creationId xmlns:a16="http://schemas.microsoft.com/office/drawing/2014/main" id="{954BF976-2B57-426E-9CB3-258BCE6F9FA5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40246" y="3088409"/>
              <a:ext cx="1403345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9pPr>
            </a:lstStyle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D-</a:t>
              </a:r>
              <a:r>
                <a:rPr lang="en-US" altLang="zh-CN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dMYBTT</a:t>
              </a:r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+LAR1-Pro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8" name="文本框 117">
              <a:extLst>
                <a:ext uri="{FF2B5EF4-FFF2-40B4-BE49-F238E27FC236}">
                  <a16:creationId xmlns:a16="http://schemas.microsoft.com/office/drawing/2014/main" id="{1F3FF044-88C2-426A-929E-D77CE6F7923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40246" y="2913855"/>
              <a:ext cx="128240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9pPr>
            </a:lstStyle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D-</a:t>
              </a:r>
              <a:r>
                <a:rPr lang="en-US" altLang="zh-CN" sz="800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mdmybtt</a:t>
              </a:r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+ LAR1-Pro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9" name="文本框 118">
              <a:extLst>
                <a:ext uri="{FF2B5EF4-FFF2-40B4-BE49-F238E27FC236}">
                  <a16:creationId xmlns:a16="http://schemas.microsoft.com/office/drawing/2014/main" id="{1BE2EDF6-0DE0-4C9D-BB10-674FE9F039B2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240246" y="2755248"/>
              <a:ext cx="1282409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  <a:ea typeface="SimSun" panose="02010600030101010101" pitchFamily="2" charset="-122"/>
                </a:defRPr>
              </a:lvl9pPr>
            </a:lstStyle>
            <a:p>
              <a:r>
                <a:rPr lang="en-US" altLang="zh-CN" sz="8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D+ LAR1-Pro</a:t>
              </a:r>
              <a:endParaRPr lang="zh-CN" altLang="en-US" sz="8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11" name="图片 110">
              <a:extLst>
                <a:ext uri="{FF2B5EF4-FFF2-40B4-BE49-F238E27FC236}">
                  <a16:creationId xmlns:a16="http://schemas.microsoft.com/office/drawing/2014/main" id="{90B4304E-DC0D-4DBC-A660-00D01F1871E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635" t="58681" r="30268" b="20946"/>
            <a:stretch/>
          </p:blipFill>
          <p:spPr>
            <a:xfrm>
              <a:off x="3570880" y="1823606"/>
              <a:ext cx="910548" cy="373658"/>
            </a:xfrm>
            <a:prstGeom prst="rect">
              <a:avLst/>
            </a:prstGeom>
          </p:spPr>
        </p:pic>
        <p:sp>
          <p:nvSpPr>
            <p:cNvPr id="68" name="文本框 67">
              <a:extLst>
                <a:ext uri="{FF2B5EF4-FFF2-40B4-BE49-F238E27FC236}">
                  <a16:creationId xmlns:a16="http://schemas.microsoft.com/office/drawing/2014/main" id="{3B1ED723-96CE-4565-8318-43BC1295F980}"/>
                </a:ext>
              </a:extLst>
            </p:cNvPr>
            <p:cNvSpPr txBox="1"/>
            <p:nvPr/>
          </p:nvSpPr>
          <p:spPr>
            <a:xfrm>
              <a:off x="6076078" y="2383958"/>
              <a:ext cx="807986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000" b="1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NR1Pro</a:t>
              </a:r>
              <a:endParaRPr lang="zh-CN" altLang="en-US" sz="10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92" name="组合 91">
              <a:extLst>
                <a:ext uri="{FF2B5EF4-FFF2-40B4-BE49-F238E27FC236}">
                  <a16:creationId xmlns:a16="http://schemas.microsoft.com/office/drawing/2014/main" id="{7CB54018-E0C9-4947-A71D-53F9C7B9CF8A}"/>
                </a:ext>
              </a:extLst>
            </p:cNvPr>
            <p:cNvGrpSpPr/>
            <p:nvPr/>
          </p:nvGrpSpPr>
          <p:grpSpPr>
            <a:xfrm>
              <a:off x="5716334" y="1498912"/>
              <a:ext cx="778373" cy="787198"/>
              <a:chOff x="5383576" y="444621"/>
              <a:chExt cx="992581" cy="1003835"/>
            </a:xfrm>
          </p:grpSpPr>
          <p:sp>
            <p:nvSpPr>
              <p:cNvPr id="150" name="任意多边形: 形状 149">
                <a:extLst>
                  <a:ext uri="{FF2B5EF4-FFF2-40B4-BE49-F238E27FC236}">
                    <a16:creationId xmlns:a16="http://schemas.microsoft.com/office/drawing/2014/main" id="{BB0436A5-5AD9-4573-888C-E8501D89BA85}"/>
                  </a:ext>
                </a:extLst>
              </p:cNvPr>
              <p:cNvSpPr/>
              <p:nvPr/>
            </p:nvSpPr>
            <p:spPr>
              <a:xfrm>
                <a:off x="5383576" y="444621"/>
                <a:ext cx="992581" cy="1003835"/>
              </a:xfrm>
              <a:custGeom>
                <a:avLst/>
                <a:gdLst>
                  <a:gd name="connsiteX0" fmla="*/ 580278 w 992581"/>
                  <a:gd name="connsiteY0" fmla="*/ 4313 h 1003835"/>
                  <a:gd name="connsiteX1" fmla="*/ 651715 w 992581"/>
                  <a:gd name="connsiteY1" fmla="*/ 49556 h 1003835"/>
                  <a:gd name="connsiteX2" fmla="*/ 723153 w 992581"/>
                  <a:gd name="connsiteY2" fmla="*/ 106706 h 1003835"/>
                  <a:gd name="connsiteX3" fmla="*/ 730296 w 992581"/>
                  <a:gd name="connsiteY3" fmla="*/ 109088 h 1003835"/>
                  <a:gd name="connsiteX4" fmla="*/ 785065 w 992581"/>
                  <a:gd name="connsiteY4" fmla="*/ 182906 h 1003835"/>
                  <a:gd name="connsiteX5" fmla="*/ 849359 w 992581"/>
                  <a:gd name="connsiteY5" fmla="*/ 244819 h 1003835"/>
                  <a:gd name="connsiteX6" fmla="*/ 889840 w 992581"/>
                  <a:gd name="connsiteY6" fmla="*/ 318638 h 1003835"/>
                  <a:gd name="connsiteX7" fmla="*/ 916034 w 992581"/>
                  <a:gd name="connsiteY7" fmla="*/ 380550 h 1003835"/>
                  <a:gd name="connsiteX8" fmla="*/ 916034 w 992581"/>
                  <a:gd name="connsiteY8" fmla="*/ 430556 h 1003835"/>
                  <a:gd name="connsiteX9" fmla="*/ 920796 w 992581"/>
                  <a:gd name="connsiteY9" fmla="*/ 463894 h 1003835"/>
                  <a:gd name="connsiteX10" fmla="*/ 949371 w 992581"/>
                  <a:gd name="connsiteY10" fmla="*/ 501994 h 1003835"/>
                  <a:gd name="connsiteX11" fmla="*/ 968421 w 992581"/>
                  <a:gd name="connsiteY11" fmla="*/ 537713 h 1003835"/>
                  <a:gd name="connsiteX12" fmla="*/ 961278 w 992581"/>
                  <a:gd name="connsiteY12" fmla="*/ 587719 h 1003835"/>
                  <a:gd name="connsiteX13" fmla="*/ 992234 w 992581"/>
                  <a:gd name="connsiteY13" fmla="*/ 644869 h 1003835"/>
                  <a:gd name="connsiteX14" fmla="*/ 975565 w 992581"/>
                  <a:gd name="connsiteY14" fmla="*/ 740119 h 1003835"/>
                  <a:gd name="connsiteX15" fmla="*/ 939846 w 992581"/>
                  <a:gd name="connsiteY15" fmla="*/ 844894 h 1003835"/>
                  <a:gd name="connsiteX16" fmla="*/ 875553 w 992581"/>
                  <a:gd name="connsiteY16" fmla="*/ 937763 h 1003835"/>
                  <a:gd name="connsiteX17" fmla="*/ 801734 w 992581"/>
                  <a:gd name="connsiteY17" fmla="*/ 966338 h 1003835"/>
                  <a:gd name="connsiteX18" fmla="*/ 732678 w 992581"/>
                  <a:gd name="connsiteY18" fmla="*/ 980625 h 1003835"/>
                  <a:gd name="connsiteX19" fmla="*/ 663621 w 992581"/>
                  <a:gd name="connsiteY19" fmla="*/ 983006 h 1003835"/>
                  <a:gd name="connsiteX20" fmla="*/ 546940 w 992581"/>
                  <a:gd name="connsiteY20" fmla="*/ 963956 h 1003835"/>
                  <a:gd name="connsiteX21" fmla="*/ 496934 w 992581"/>
                  <a:gd name="connsiteY21" fmla="*/ 963956 h 1003835"/>
                  <a:gd name="connsiteX22" fmla="*/ 404065 w 992581"/>
                  <a:gd name="connsiteY22" fmla="*/ 966338 h 1003835"/>
                  <a:gd name="connsiteX23" fmla="*/ 346915 w 992581"/>
                  <a:gd name="connsiteY23" fmla="*/ 968719 h 1003835"/>
                  <a:gd name="connsiteX24" fmla="*/ 313578 w 992581"/>
                  <a:gd name="connsiteY24" fmla="*/ 1002056 h 1003835"/>
                  <a:gd name="connsiteX25" fmla="*/ 208803 w 992581"/>
                  <a:gd name="connsiteY25" fmla="*/ 990150 h 1003835"/>
                  <a:gd name="connsiteX26" fmla="*/ 115934 w 992581"/>
                  <a:gd name="connsiteY26" fmla="*/ 913950 h 1003835"/>
                  <a:gd name="connsiteX27" fmla="*/ 54021 w 992581"/>
                  <a:gd name="connsiteY27" fmla="*/ 835369 h 1003835"/>
                  <a:gd name="connsiteX28" fmla="*/ 39734 w 992581"/>
                  <a:gd name="connsiteY28" fmla="*/ 744881 h 1003835"/>
                  <a:gd name="connsiteX29" fmla="*/ 32590 w 992581"/>
                  <a:gd name="connsiteY29" fmla="*/ 725831 h 1003835"/>
                  <a:gd name="connsiteX30" fmla="*/ 44496 w 992581"/>
                  <a:gd name="connsiteY30" fmla="*/ 690113 h 1003835"/>
                  <a:gd name="connsiteX31" fmla="*/ 51640 w 992581"/>
                  <a:gd name="connsiteY31" fmla="*/ 659156 h 1003835"/>
                  <a:gd name="connsiteX32" fmla="*/ 13540 w 992581"/>
                  <a:gd name="connsiteY32" fmla="*/ 594863 h 1003835"/>
                  <a:gd name="connsiteX33" fmla="*/ 4015 w 992581"/>
                  <a:gd name="connsiteY33" fmla="*/ 530569 h 1003835"/>
                  <a:gd name="connsiteX34" fmla="*/ 75453 w 992581"/>
                  <a:gd name="connsiteY34" fmla="*/ 421031 h 1003835"/>
                  <a:gd name="connsiteX35" fmla="*/ 113553 w 992581"/>
                  <a:gd name="connsiteY35" fmla="*/ 330544 h 1003835"/>
                  <a:gd name="connsiteX36" fmla="*/ 177846 w 992581"/>
                  <a:gd name="connsiteY36" fmla="*/ 251963 h 1003835"/>
                  <a:gd name="connsiteX37" fmla="*/ 265953 w 992581"/>
                  <a:gd name="connsiteY37" fmla="*/ 204338 h 1003835"/>
                  <a:gd name="connsiteX38" fmla="*/ 306434 w 992581"/>
                  <a:gd name="connsiteY38" fmla="*/ 154331 h 1003835"/>
                  <a:gd name="connsiteX39" fmla="*/ 354059 w 992581"/>
                  <a:gd name="connsiteY39" fmla="*/ 80513 h 1003835"/>
                  <a:gd name="connsiteX40" fmla="*/ 406446 w 992581"/>
                  <a:gd name="connsiteY40" fmla="*/ 40031 h 1003835"/>
                  <a:gd name="connsiteX41" fmla="*/ 485028 w 992581"/>
                  <a:gd name="connsiteY41" fmla="*/ 6694 h 1003835"/>
                  <a:gd name="connsiteX42" fmla="*/ 580278 w 992581"/>
                  <a:gd name="connsiteY42" fmla="*/ 4313 h 100383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</a:cxnLst>
                <a:rect l="l" t="t" r="r" b="b"/>
                <a:pathLst>
                  <a:path w="992581" h="1003835">
                    <a:moveTo>
                      <a:pt x="580278" y="4313"/>
                    </a:moveTo>
                    <a:cubicBezTo>
                      <a:pt x="608059" y="11457"/>
                      <a:pt x="627902" y="32490"/>
                      <a:pt x="651715" y="49556"/>
                    </a:cubicBezTo>
                    <a:cubicBezTo>
                      <a:pt x="675528" y="66622"/>
                      <a:pt x="710056" y="96784"/>
                      <a:pt x="723153" y="106706"/>
                    </a:cubicBezTo>
                    <a:cubicBezTo>
                      <a:pt x="736250" y="116628"/>
                      <a:pt x="719977" y="96388"/>
                      <a:pt x="730296" y="109088"/>
                    </a:cubicBezTo>
                    <a:cubicBezTo>
                      <a:pt x="740615" y="121788"/>
                      <a:pt x="765221" y="160284"/>
                      <a:pt x="785065" y="182906"/>
                    </a:cubicBezTo>
                    <a:cubicBezTo>
                      <a:pt x="804909" y="205528"/>
                      <a:pt x="831897" y="222197"/>
                      <a:pt x="849359" y="244819"/>
                    </a:cubicBezTo>
                    <a:cubicBezTo>
                      <a:pt x="866821" y="267441"/>
                      <a:pt x="878728" y="296016"/>
                      <a:pt x="889840" y="318638"/>
                    </a:cubicBezTo>
                    <a:cubicBezTo>
                      <a:pt x="900952" y="341260"/>
                      <a:pt x="911668" y="361897"/>
                      <a:pt x="916034" y="380550"/>
                    </a:cubicBezTo>
                    <a:cubicBezTo>
                      <a:pt x="920400" y="399203"/>
                      <a:pt x="915240" y="416665"/>
                      <a:pt x="916034" y="430556"/>
                    </a:cubicBezTo>
                    <a:cubicBezTo>
                      <a:pt x="916828" y="444447"/>
                      <a:pt x="915240" y="451988"/>
                      <a:pt x="920796" y="463894"/>
                    </a:cubicBezTo>
                    <a:cubicBezTo>
                      <a:pt x="926352" y="475800"/>
                      <a:pt x="941434" y="489691"/>
                      <a:pt x="949371" y="501994"/>
                    </a:cubicBezTo>
                    <a:cubicBezTo>
                      <a:pt x="957308" y="514297"/>
                      <a:pt x="966437" y="523426"/>
                      <a:pt x="968421" y="537713"/>
                    </a:cubicBezTo>
                    <a:cubicBezTo>
                      <a:pt x="970405" y="552000"/>
                      <a:pt x="957309" y="569860"/>
                      <a:pt x="961278" y="587719"/>
                    </a:cubicBezTo>
                    <a:cubicBezTo>
                      <a:pt x="965247" y="605578"/>
                      <a:pt x="989853" y="619469"/>
                      <a:pt x="992234" y="644869"/>
                    </a:cubicBezTo>
                    <a:cubicBezTo>
                      <a:pt x="994615" y="670269"/>
                      <a:pt x="984296" y="706782"/>
                      <a:pt x="975565" y="740119"/>
                    </a:cubicBezTo>
                    <a:cubicBezTo>
                      <a:pt x="966834" y="773456"/>
                      <a:pt x="956515" y="811953"/>
                      <a:pt x="939846" y="844894"/>
                    </a:cubicBezTo>
                    <a:cubicBezTo>
                      <a:pt x="923177" y="877835"/>
                      <a:pt x="898572" y="917522"/>
                      <a:pt x="875553" y="937763"/>
                    </a:cubicBezTo>
                    <a:cubicBezTo>
                      <a:pt x="852534" y="958004"/>
                      <a:pt x="825546" y="959194"/>
                      <a:pt x="801734" y="966338"/>
                    </a:cubicBezTo>
                    <a:cubicBezTo>
                      <a:pt x="777922" y="973482"/>
                      <a:pt x="755697" y="977847"/>
                      <a:pt x="732678" y="980625"/>
                    </a:cubicBezTo>
                    <a:cubicBezTo>
                      <a:pt x="709659" y="983403"/>
                      <a:pt x="694577" y="985784"/>
                      <a:pt x="663621" y="983006"/>
                    </a:cubicBezTo>
                    <a:cubicBezTo>
                      <a:pt x="632665" y="980228"/>
                      <a:pt x="574721" y="967131"/>
                      <a:pt x="546940" y="963956"/>
                    </a:cubicBezTo>
                    <a:cubicBezTo>
                      <a:pt x="519159" y="960781"/>
                      <a:pt x="496934" y="963956"/>
                      <a:pt x="496934" y="963956"/>
                    </a:cubicBezTo>
                    <a:lnTo>
                      <a:pt x="404065" y="966338"/>
                    </a:lnTo>
                    <a:cubicBezTo>
                      <a:pt x="379062" y="967132"/>
                      <a:pt x="361996" y="962766"/>
                      <a:pt x="346915" y="968719"/>
                    </a:cubicBezTo>
                    <a:cubicBezTo>
                      <a:pt x="331834" y="974672"/>
                      <a:pt x="336597" y="998484"/>
                      <a:pt x="313578" y="1002056"/>
                    </a:cubicBezTo>
                    <a:cubicBezTo>
                      <a:pt x="290559" y="1005628"/>
                      <a:pt x="241744" y="1004834"/>
                      <a:pt x="208803" y="990150"/>
                    </a:cubicBezTo>
                    <a:cubicBezTo>
                      <a:pt x="175862" y="975466"/>
                      <a:pt x="141731" y="939747"/>
                      <a:pt x="115934" y="913950"/>
                    </a:cubicBezTo>
                    <a:cubicBezTo>
                      <a:pt x="90137" y="888153"/>
                      <a:pt x="66721" y="863547"/>
                      <a:pt x="54021" y="835369"/>
                    </a:cubicBezTo>
                    <a:cubicBezTo>
                      <a:pt x="41321" y="807191"/>
                      <a:pt x="43306" y="763137"/>
                      <a:pt x="39734" y="744881"/>
                    </a:cubicBezTo>
                    <a:cubicBezTo>
                      <a:pt x="36162" y="726625"/>
                      <a:pt x="31796" y="734959"/>
                      <a:pt x="32590" y="725831"/>
                    </a:cubicBezTo>
                    <a:cubicBezTo>
                      <a:pt x="33384" y="716703"/>
                      <a:pt x="41321" y="701226"/>
                      <a:pt x="44496" y="690113"/>
                    </a:cubicBezTo>
                    <a:cubicBezTo>
                      <a:pt x="47671" y="679000"/>
                      <a:pt x="56799" y="675031"/>
                      <a:pt x="51640" y="659156"/>
                    </a:cubicBezTo>
                    <a:cubicBezTo>
                      <a:pt x="46481" y="643281"/>
                      <a:pt x="21477" y="616294"/>
                      <a:pt x="13540" y="594863"/>
                    </a:cubicBezTo>
                    <a:cubicBezTo>
                      <a:pt x="5603" y="573432"/>
                      <a:pt x="-6304" y="559541"/>
                      <a:pt x="4015" y="530569"/>
                    </a:cubicBezTo>
                    <a:cubicBezTo>
                      <a:pt x="14334" y="501597"/>
                      <a:pt x="57197" y="454369"/>
                      <a:pt x="75453" y="421031"/>
                    </a:cubicBezTo>
                    <a:cubicBezTo>
                      <a:pt x="93709" y="387693"/>
                      <a:pt x="96488" y="358722"/>
                      <a:pt x="113553" y="330544"/>
                    </a:cubicBezTo>
                    <a:cubicBezTo>
                      <a:pt x="130618" y="302366"/>
                      <a:pt x="152446" y="272997"/>
                      <a:pt x="177846" y="251963"/>
                    </a:cubicBezTo>
                    <a:cubicBezTo>
                      <a:pt x="203246" y="230929"/>
                      <a:pt x="244522" y="220610"/>
                      <a:pt x="265953" y="204338"/>
                    </a:cubicBezTo>
                    <a:cubicBezTo>
                      <a:pt x="287384" y="188066"/>
                      <a:pt x="291750" y="174968"/>
                      <a:pt x="306434" y="154331"/>
                    </a:cubicBezTo>
                    <a:cubicBezTo>
                      <a:pt x="321118" y="133694"/>
                      <a:pt x="337390" y="99563"/>
                      <a:pt x="354059" y="80513"/>
                    </a:cubicBezTo>
                    <a:cubicBezTo>
                      <a:pt x="370728" y="61463"/>
                      <a:pt x="384618" y="52334"/>
                      <a:pt x="406446" y="40031"/>
                    </a:cubicBezTo>
                    <a:cubicBezTo>
                      <a:pt x="428274" y="27728"/>
                      <a:pt x="461612" y="13838"/>
                      <a:pt x="485028" y="6694"/>
                    </a:cubicBezTo>
                    <a:cubicBezTo>
                      <a:pt x="508444" y="-450"/>
                      <a:pt x="552497" y="-2831"/>
                      <a:pt x="580278" y="4313"/>
                    </a:cubicBezTo>
                    <a:close/>
                  </a:path>
                </a:pathLst>
              </a:custGeom>
              <a:solidFill>
                <a:schemeClr val="bg2">
                  <a:lumMod val="9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/>
              </a:p>
            </p:txBody>
          </p:sp>
          <p:sp>
            <p:nvSpPr>
              <p:cNvPr id="145" name="任意多边形: 形状 144">
                <a:extLst>
                  <a:ext uri="{FF2B5EF4-FFF2-40B4-BE49-F238E27FC236}">
                    <a16:creationId xmlns:a16="http://schemas.microsoft.com/office/drawing/2014/main" id="{48DFFBDA-8FFA-416B-A531-05F33661CC5B}"/>
                  </a:ext>
                </a:extLst>
              </p:cNvPr>
              <p:cNvSpPr/>
              <p:nvPr/>
            </p:nvSpPr>
            <p:spPr>
              <a:xfrm>
                <a:off x="5841766" y="486956"/>
                <a:ext cx="76200" cy="919163"/>
              </a:xfrm>
              <a:custGeom>
                <a:avLst/>
                <a:gdLst>
                  <a:gd name="connsiteX0" fmla="*/ 76200 w 76200"/>
                  <a:gd name="connsiteY0" fmla="*/ 0 h 919163"/>
                  <a:gd name="connsiteX1" fmla="*/ 42862 w 76200"/>
                  <a:gd name="connsiteY1" fmla="*/ 242888 h 919163"/>
                  <a:gd name="connsiteX2" fmla="*/ 14287 w 76200"/>
                  <a:gd name="connsiteY2" fmla="*/ 450056 h 919163"/>
                  <a:gd name="connsiteX3" fmla="*/ 14287 w 76200"/>
                  <a:gd name="connsiteY3" fmla="*/ 659606 h 919163"/>
                  <a:gd name="connsiteX4" fmla="*/ 0 w 76200"/>
                  <a:gd name="connsiteY4" fmla="*/ 919163 h 919163"/>
                  <a:gd name="connsiteX5" fmla="*/ 0 w 76200"/>
                  <a:gd name="connsiteY5" fmla="*/ 919163 h 91916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76200" h="919163">
                    <a:moveTo>
                      <a:pt x="76200" y="0"/>
                    </a:moveTo>
                    <a:lnTo>
                      <a:pt x="42862" y="242888"/>
                    </a:lnTo>
                    <a:cubicBezTo>
                      <a:pt x="32543" y="317897"/>
                      <a:pt x="19049" y="380603"/>
                      <a:pt x="14287" y="450056"/>
                    </a:cubicBezTo>
                    <a:cubicBezTo>
                      <a:pt x="9525" y="519509"/>
                      <a:pt x="16668" y="581422"/>
                      <a:pt x="14287" y="659606"/>
                    </a:cubicBezTo>
                    <a:cubicBezTo>
                      <a:pt x="11906" y="737790"/>
                      <a:pt x="0" y="919163"/>
                      <a:pt x="0" y="919163"/>
                    </a:cubicBezTo>
                    <a:lnTo>
                      <a:pt x="0" y="919163"/>
                    </a:ln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/>
              </a:p>
            </p:txBody>
          </p:sp>
          <p:sp>
            <p:nvSpPr>
              <p:cNvPr id="146" name="任意多边形: 形状 145">
                <a:extLst>
                  <a:ext uri="{FF2B5EF4-FFF2-40B4-BE49-F238E27FC236}">
                    <a16:creationId xmlns:a16="http://schemas.microsoft.com/office/drawing/2014/main" id="{4957585B-7B82-46DB-A033-A2BEA44F403C}"/>
                  </a:ext>
                </a:extLst>
              </p:cNvPr>
              <p:cNvSpPr/>
              <p:nvPr/>
            </p:nvSpPr>
            <p:spPr>
              <a:xfrm>
                <a:off x="5854285" y="659334"/>
                <a:ext cx="336155" cy="511969"/>
              </a:xfrm>
              <a:custGeom>
                <a:avLst/>
                <a:gdLst>
                  <a:gd name="connsiteX0" fmla="*/ 0 w 336155"/>
                  <a:gd name="connsiteY0" fmla="*/ 511969 h 511969"/>
                  <a:gd name="connsiteX1" fmla="*/ 69056 w 336155"/>
                  <a:gd name="connsiteY1" fmla="*/ 461963 h 511969"/>
                  <a:gd name="connsiteX2" fmla="*/ 190500 w 336155"/>
                  <a:gd name="connsiteY2" fmla="*/ 369094 h 511969"/>
                  <a:gd name="connsiteX3" fmla="*/ 264319 w 336155"/>
                  <a:gd name="connsiteY3" fmla="*/ 273844 h 511969"/>
                  <a:gd name="connsiteX4" fmla="*/ 314325 w 336155"/>
                  <a:gd name="connsiteY4" fmla="*/ 214313 h 511969"/>
                  <a:gd name="connsiteX5" fmla="*/ 335756 w 336155"/>
                  <a:gd name="connsiteY5" fmla="*/ 88107 h 511969"/>
                  <a:gd name="connsiteX6" fmla="*/ 326231 w 336155"/>
                  <a:gd name="connsiteY6" fmla="*/ 0 h 51196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</a:cxnLst>
                <a:rect l="l" t="t" r="r" b="b"/>
                <a:pathLst>
                  <a:path w="336155" h="511969">
                    <a:moveTo>
                      <a:pt x="0" y="511969"/>
                    </a:moveTo>
                    <a:cubicBezTo>
                      <a:pt x="19050" y="498078"/>
                      <a:pt x="37306" y="485775"/>
                      <a:pt x="69056" y="461963"/>
                    </a:cubicBezTo>
                    <a:cubicBezTo>
                      <a:pt x="100806" y="438151"/>
                      <a:pt x="157956" y="400447"/>
                      <a:pt x="190500" y="369094"/>
                    </a:cubicBezTo>
                    <a:cubicBezTo>
                      <a:pt x="223044" y="337741"/>
                      <a:pt x="243682" y="299641"/>
                      <a:pt x="264319" y="273844"/>
                    </a:cubicBezTo>
                    <a:cubicBezTo>
                      <a:pt x="284957" y="248047"/>
                      <a:pt x="302419" y="245269"/>
                      <a:pt x="314325" y="214313"/>
                    </a:cubicBezTo>
                    <a:cubicBezTo>
                      <a:pt x="326231" y="183357"/>
                      <a:pt x="333772" y="123826"/>
                      <a:pt x="335756" y="88107"/>
                    </a:cubicBezTo>
                    <a:cubicBezTo>
                      <a:pt x="337740" y="52388"/>
                      <a:pt x="331985" y="26194"/>
                      <a:pt x="326231" y="0"/>
                    </a:cubicBez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/>
              </a:p>
            </p:txBody>
          </p:sp>
          <p:sp>
            <p:nvSpPr>
              <p:cNvPr id="147" name="任意多边形: 形状 146">
                <a:extLst>
                  <a:ext uri="{FF2B5EF4-FFF2-40B4-BE49-F238E27FC236}">
                    <a16:creationId xmlns:a16="http://schemas.microsoft.com/office/drawing/2014/main" id="{54173AA9-F04C-49D7-B39D-A448AB7D72FB}"/>
                  </a:ext>
                </a:extLst>
              </p:cNvPr>
              <p:cNvSpPr/>
              <p:nvPr/>
            </p:nvSpPr>
            <p:spPr>
              <a:xfrm>
                <a:off x="5567471" y="684720"/>
                <a:ext cx="283369" cy="511968"/>
              </a:xfrm>
              <a:custGeom>
                <a:avLst/>
                <a:gdLst>
                  <a:gd name="connsiteX0" fmla="*/ 28575 w 283369"/>
                  <a:gd name="connsiteY0" fmla="*/ 0 h 511968"/>
                  <a:gd name="connsiteX1" fmla="*/ 0 w 283369"/>
                  <a:gd name="connsiteY1" fmla="*/ 123825 h 511968"/>
                  <a:gd name="connsiteX2" fmla="*/ 28575 w 283369"/>
                  <a:gd name="connsiteY2" fmla="*/ 235743 h 511968"/>
                  <a:gd name="connsiteX3" fmla="*/ 147638 w 283369"/>
                  <a:gd name="connsiteY3" fmla="*/ 376237 h 511968"/>
                  <a:gd name="connsiteX4" fmla="*/ 283369 w 283369"/>
                  <a:gd name="connsiteY4" fmla="*/ 511968 h 51196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283369" h="511968">
                    <a:moveTo>
                      <a:pt x="28575" y="0"/>
                    </a:moveTo>
                    <a:cubicBezTo>
                      <a:pt x="14287" y="42267"/>
                      <a:pt x="0" y="84535"/>
                      <a:pt x="0" y="123825"/>
                    </a:cubicBezTo>
                    <a:cubicBezTo>
                      <a:pt x="0" y="163115"/>
                      <a:pt x="3969" y="193674"/>
                      <a:pt x="28575" y="235743"/>
                    </a:cubicBezTo>
                    <a:cubicBezTo>
                      <a:pt x="53181" y="277812"/>
                      <a:pt x="105172" y="330200"/>
                      <a:pt x="147638" y="376237"/>
                    </a:cubicBezTo>
                    <a:cubicBezTo>
                      <a:pt x="190104" y="422275"/>
                      <a:pt x="236736" y="467121"/>
                      <a:pt x="283369" y="511968"/>
                    </a:cubicBez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/>
              </a:p>
            </p:txBody>
          </p:sp>
          <p:sp>
            <p:nvSpPr>
              <p:cNvPr id="148" name="任意多边形: 形状 147">
                <a:extLst>
                  <a:ext uri="{FF2B5EF4-FFF2-40B4-BE49-F238E27FC236}">
                    <a16:creationId xmlns:a16="http://schemas.microsoft.com/office/drawing/2014/main" id="{757F7AC3-937D-48DB-A196-A7F0958EC051}"/>
                  </a:ext>
                </a:extLst>
              </p:cNvPr>
              <p:cNvSpPr/>
              <p:nvPr/>
            </p:nvSpPr>
            <p:spPr>
              <a:xfrm>
                <a:off x="5841766" y="1143015"/>
                <a:ext cx="390525" cy="238125"/>
              </a:xfrm>
              <a:custGeom>
                <a:avLst/>
                <a:gdLst>
                  <a:gd name="connsiteX0" fmla="*/ 0 w 390525"/>
                  <a:gd name="connsiteY0" fmla="*/ 238125 h 238125"/>
                  <a:gd name="connsiteX1" fmla="*/ 114300 w 390525"/>
                  <a:gd name="connsiteY1" fmla="*/ 180975 h 238125"/>
                  <a:gd name="connsiteX2" fmla="*/ 176213 w 390525"/>
                  <a:gd name="connsiteY2" fmla="*/ 164306 h 238125"/>
                  <a:gd name="connsiteX3" fmla="*/ 266700 w 390525"/>
                  <a:gd name="connsiteY3" fmla="*/ 123825 h 238125"/>
                  <a:gd name="connsiteX4" fmla="*/ 347663 w 390525"/>
                  <a:gd name="connsiteY4" fmla="*/ 40481 h 238125"/>
                  <a:gd name="connsiteX5" fmla="*/ 390525 w 390525"/>
                  <a:gd name="connsiteY5" fmla="*/ 0 h 23812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</a:cxnLst>
                <a:rect l="l" t="t" r="r" b="b"/>
                <a:pathLst>
                  <a:path w="390525" h="238125">
                    <a:moveTo>
                      <a:pt x="0" y="238125"/>
                    </a:moveTo>
                    <a:cubicBezTo>
                      <a:pt x="42465" y="215701"/>
                      <a:pt x="84931" y="193278"/>
                      <a:pt x="114300" y="180975"/>
                    </a:cubicBezTo>
                    <a:cubicBezTo>
                      <a:pt x="143669" y="168672"/>
                      <a:pt x="150813" y="173831"/>
                      <a:pt x="176213" y="164306"/>
                    </a:cubicBezTo>
                    <a:cubicBezTo>
                      <a:pt x="201613" y="154781"/>
                      <a:pt x="238125" y="144462"/>
                      <a:pt x="266700" y="123825"/>
                    </a:cubicBezTo>
                    <a:cubicBezTo>
                      <a:pt x="295275" y="103188"/>
                      <a:pt x="327026" y="61118"/>
                      <a:pt x="347663" y="40481"/>
                    </a:cubicBezTo>
                    <a:cubicBezTo>
                      <a:pt x="368300" y="19844"/>
                      <a:pt x="379412" y="9922"/>
                      <a:pt x="390525" y="0"/>
                    </a:cubicBez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/>
              </a:p>
            </p:txBody>
          </p:sp>
          <p:sp>
            <p:nvSpPr>
              <p:cNvPr id="149" name="任意多边形: 形状 148">
                <a:extLst>
                  <a:ext uri="{FF2B5EF4-FFF2-40B4-BE49-F238E27FC236}">
                    <a16:creationId xmlns:a16="http://schemas.microsoft.com/office/drawing/2014/main" id="{65D18C6F-3440-4A76-B8A9-68D4C2FF4083}"/>
                  </a:ext>
                </a:extLst>
              </p:cNvPr>
              <p:cNvSpPr/>
              <p:nvPr/>
            </p:nvSpPr>
            <p:spPr>
              <a:xfrm>
                <a:off x="5510242" y="1273171"/>
                <a:ext cx="330993" cy="130969"/>
              </a:xfrm>
              <a:custGeom>
                <a:avLst/>
                <a:gdLst>
                  <a:gd name="connsiteX0" fmla="*/ 330993 w 330993"/>
                  <a:gd name="connsiteY0" fmla="*/ 130969 h 130969"/>
                  <a:gd name="connsiteX1" fmla="*/ 278606 w 330993"/>
                  <a:gd name="connsiteY1" fmla="*/ 100013 h 130969"/>
                  <a:gd name="connsiteX2" fmla="*/ 164306 w 330993"/>
                  <a:gd name="connsiteY2" fmla="*/ 69056 h 130969"/>
                  <a:gd name="connsiteX3" fmla="*/ 57150 w 330993"/>
                  <a:gd name="connsiteY3" fmla="*/ 19050 h 130969"/>
                  <a:gd name="connsiteX4" fmla="*/ 0 w 330993"/>
                  <a:gd name="connsiteY4" fmla="*/ 0 h 13096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330993" h="130969">
                    <a:moveTo>
                      <a:pt x="330993" y="130969"/>
                    </a:moveTo>
                    <a:cubicBezTo>
                      <a:pt x="318690" y="120650"/>
                      <a:pt x="306387" y="110332"/>
                      <a:pt x="278606" y="100013"/>
                    </a:cubicBezTo>
                    <a:cubicBezTo>
                      <a:pt x="250825" y="89694"/>
                      <a:pt x="201215" y="82550"/>
                      <a:pt x="164306" y="69056"/>
                    </a:cubicBezTo>
                    <a:cubicBezTo>
                      <a:pt x="127397" y="55562"/>
                      <a:pt x="84534" y="30559"/>
                      <a:pt x="57150" y="19050"/>
                    </a:cubicBezTo>
                    <a:cubicBezTo>
                      <a:pt x="29766" y="7541"/>
                      <a:pt x="14883" y="3770"/>
                      <a:pt x="0" y="0"/>
                    </a:cubicBezTo>
                  </a:path>
                </a:pathLst>
              </a:cu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/>
              </a:p>
            </p:txBody>
          </p:sp>
          <p:sp>
            <p:nvSpPr>
              <p:cNvPr id="83" name="椭圆 82">
                <a:extLst>
                  <a:ext uri="{FF2B5EF4-FFF2-40B4-BE49-F238E27FC236}">
                    <a16:creationId xmlns:a16="http://schemas.microsoft.com/office/drawing/2014/main" id="{D8D0C481-D1E3-4CEB-8B1B-A7791ED8F26D}"/>
                  </a:ext>
                </a:extLst>
              </p:cNvPr>
              <p:cNvSpPr/>
              <p:nvPr/>
            </p:nvSpPr>
            <p:spPr>
              <a:xfrm>
                <a:off x="5628171" y="553374"/>
                <a:ext cx="588816" cy="364621"/>
              </a:xfrm>
              <a:prstGeom prst="ellipse">
                <a:avLst/>
              </a:prstGeom>
              <a:solidFill>
                <a:srgbClr val="2473B4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8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78</a:t>
                </a:r>
                <a:endParaRPr lang="zh-CN" altLang="en-US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1" name="椭圆 150">
                <a:extLst>
                  <a:ext uri="{FF2B5EF4-FFF2-40B4-BE49-F238E27FC236}">
                    <a16:creationId xmlns:a16="http://schemas.microsoft.com/office/drawing/2014/main" id="{193C738B-D2A5-404E-91F7-583A5DADC0D0}"/>
                  </a:ext>
                </a:extLst>
              </p:cNvPr>
              <p:cNvSpPr/>
              <p:nvPr/>
            </p:nvSpPr>
            <p:spPr>
              <a:xfrm>
                <a:off x="5453514" y="962523"/>
                <a:ext cx="372425" cy="305444"/>
              </a:xfrm>
              <a:prstGeom prst="ellipse">
                <a:avLst/>
              </a:prstGeom>
              <a:solidFill>
                <a:srgbClr val="2473B4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800" dirty="0"/>
                  <a:t>T</a:t>
                </a:r>
                <a:endParaRPr lang="zh-CN" altLang="en-US" sz="800" dirty="0"/>
              </a:p>
            </p:txBody>
          </p:sp>
          <p:sp>
            <p:nvSpPr>
              <p:cNvPr id="152" name="椭圆 151">
                <a:extLst>
                  <a:ext uri="{FF2B5EF4-FFF2-40B4-BE49-F238E27FC236}">
                    <a16:creationId xmlns:a16="http://schemas.microsoft.com/office/drawing/2014/main" id="{FFA27BF1-8D5F-4BD1-87A8-2A0B991F7DD4}"/>
                  </a:ext>
                </a:extLst>
              </p:cNvPr>
              <p:cNvSpPr/>
              <p:nvPr/>
            </p:nvSpPr>
            <p:spPr>
              <a:xfrm>
                <a:off x="5947537" y="956632"/>
                <a:ext cx="372425" cy="305444"/>
              </a:xfrm>
              <a:prstGeom prst="ellipse">
                <a:avLst/>
              </a:prstGeom>
              <a:solidFill>
                <a:srgbClr val="2473B4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zh-CN" sz="800" dirty="0"/>
                  <a:t>t</a:t>
                </a:r>
                <a:endParaRPr lang="zh-CN" altLang="en-US" sz="800" dirty="0"/>
              </a:p>
            </p:txBody>
          </p:sp>
        </p:grpSp>
        <p:sp>
          <p:nvSpPr>
            <p:cNvPr id="143" name="文本框 142">
              <a:extLst>
                <a:ext uri="{FF2B5EF4-FFF2-40B4-BE49-F238E27FC236}">
                  <a16:creationId xmlns:a16="http://schemas.microsoft.com/office/drawing/2014/main" id="{55333960-5A1F-425D-9911-BB73491C257E}"/>
                </a:ext>
              </a:extLst>
            </p:cNvPr>
            <p:cNvSpPr txBox="1"/>
            <p:nvPr/>
          </p:nvSpPr>
          <p:spPr>
            <a:xfrm>
              <a:off x="2183031" y="1431841"/>
              <a:ext cx="11443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4" name="文本框 143">
              <a:extLst>
                <a:ext uri="{FF2B5EF4-FFF2-40B4-BE49-F238E27FC236}">
                  <a16:creationId xmlns:a16="http://schemas.microsoft.com/office/drawing/2014/main" id="{7E49F414-FF33-4E0F-979D-344D3B1B5B1F}"/>
                </a:ext>
              </a:extLst>
            </p:cNvPr>
            <p:cNvSpPr txBox="1"/>
            <p:nvPr/>
          </p:nvSpPr>
          <p:spPr>
            <a:xfrm>
              <a:off x="5545643" y="1415673"/>
              <a:ext cx="1010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3" name="文本框 152">
              <a:extLst>
                <a:ext uri="{FF2B5EF4-FFF2-40B4-BE49-F238E27FC236}">
                  <a16:creationId xmlns:a16="http://schemas.microsoft.com/office/drawing/2014/main" id="{2440E2A3-BFC8-478D-A302-8243520EE160}"/>
                </a:ext>
              </a:extLst>
            </p:cNvPr>
            <p:cNvSpPr txBox="1"/>
            <p:nvPr/>
          </p:nvSpPr>
          <p:spPr>
            <a:xfrm>
              <a:off x="5558580" y="3294269"/>
              <a:ext cx="101052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  <a:endParaRPr lang="zh-CN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13" name="组合 12">
              <a:extLst>
                <a:ext uri="{FF2B5EF4-FFF2-40B4-BE49-F238E27FC236}">
                  <a16:creationId xmlns:a16="http://schemas.microsoft.com/office/drawing/2014/main" id="{6FF8F534-F244-4B6B-AD60-B4411D65881F}"/>
                </a:ext>
              </a:extLst>
            </p:cNvPr>
            <p:cNvGrpSpPr/>
            <p:nvPr/>
          </p:nvGrpSpPr>
          <p:grpSpPr>
            <a:xfrm>
              <a:off x="7624121" y="1418644"/>
              <a:ext cx="1016896" cy="925940"/>
              <a:chOff x="8279649" y="522097"/>
              <a:chExt cx="1482763" cy="1332385"/>
            </a:xfrm>
          </p:grpSpPr>
          <p:pic>
            <p:nvPicPr>
              <p:cNvPr id="22" name="图片 21">
                <a:extLst>
                  <a:ext uri="{FF2B5EF4-FFF2-40B4-BE49-F238E27FC236}">
                    <a16:creationId xmlns:a16="http://schemas.microsoft.com/office/drawing/2014/main" id="{633D7692-218A-41C2-B888-E997F885D03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3783" t="18081" r="14909" b="15060"/>
              <a:stretch/>
            </p:blipFill>
            <p:spPr>
              <a:xfrm>
                <a:off x="8279649" y="622452"/>
                <a:ext cx="1086108" cy="1148075"/>
              </a:xfrm>
              <a:prstGeom prst="rect">
                <a:avLst/>
              </a:prstGeom>
            </p:spPr>
          </p:pic>
          <p:sp>
            <p:nvSpPr>
              <p:cNvPr id="109" name="文本框 108">
                <a:extLst>
                  <a:ext uri="{FF2B5EF4-FFF2-40B4-BE49-F238E27FC236}">
                    <a16:creationId xmlns:a16="http://schemas.microsoft.com/office/drawing/2014/main" id="{826D8581-1657-45F9-8908-947C0FC96AC4}"/>
                  </a:ext>
                </a:extLst>
              </p:cNvPr>
              <p:cNvSpPr txBox="1"/>
              <p:nvPr/>
            </p:nvSpPr>
            <p:spPr>
              <a:xfrm>
                <a:off x="8492379" y="1485417"/>
                <a:ext cx="1178147" cy="31001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AR1Pro</a:t>
                </a:r>
                <a:endParaRPr lang="zh-CN" altLang="en-US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1" name="矩形 180">
                <a:extLst>
                  <a:ext uri="{FF2B5EF4-FFF2-40B4-BE49-F238E27FC236}">
                    <a16:creationId xmlns:a16="http://schemas.microsoft.com/office/drawing/2014/main" id="{DE60BCED-E6AB-4C32-BDA3-F077BA95D686}"/>
                  </a:ext>
                </a:extLst>
              </p:cNvPr>
              <p:cNvSpPr/>
              <p:nvPr/>
            </p:nvSpPr>
            <p:spPr>
              <a:xfrm>
                <a:off x="9352381" y="622452"/>
                <a:ext cx="209993" cy="1148075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/>
              </a:p>
            </p:txBody>
          </p:sp>
          <p:sp>
            <p:nvSpPr>
              <p:cNvPr id="182" name="矩形 181">
                <a:extLst>
                  <a:ext uri="{FF2B5EF4-FFF2-40B4-BE49-F238E27FC236}">
                    <a16:creationId xmlns:a16="http://schemas.microsoft.com/office/drawing/2014/main" id="{B9ECEFFD-068C-4F01-95C8-97EDF26BF005}"/>
                  </a:ext>
                </a:extLst>
              </p:cNvPr>
              <p:cNvSpPr/>
              <p:nvPr/>
            </p:nvSpPr>
            <p:spPr>
              <a:xfrm>
                <a:off x="9397102" y="724158"/>
                <a:ext cx="94040" cy="946509"/>
              </a:xfrm>
              <a:prstGeom prst="rect">
                <a:avLst/>
              </a:prstGeom>
              <a:gradFill>
                <a:gsLst>
                  <a:gs pos="0">
                    <a:srgbClr val="FF0900"/>
                  </a:gs>
                  <a:gs pos="31471">
                    <a:srgbClr val="FFFF00"/>
                  </a:gs>
                  <a:gs pos="22000">
                    <a:srgbClr val="FFEC00"/>
                  </a:gs>
                  <a:gs pos="65000">
                    <a:srgbClr val="00F3FF"/>
                  </a:gs>
                  <a:gs pos="84000">
                    <a:srgbClr val="0000E0"/>
                  </a:gs>
                  <a:gs pos="47188">
                    <a:srgbClr val="00FF29"/>
                  </a:gs>
                  <a:gs pos="100000">
                    <a:schemeClr val="tx1"/>
                  </a:gs>
                </a:gsLst>
                <a:lin ang="5400000" scaled="0"/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/>
              </a:p>
            </p:txBody>
          </p:sp>
          <p:sp>
            <p:nvSpPr>
              <p:cNvPr id="183" name="文本框 182">
                <a:extLst>
                  <a:ext uri="{FF2B5EF4-FFF2-40B4-BE49-F238E27FC236}">
                    <a16:creationId xmlns:a16="http://schemas.microsoft.com/office/drawing/2014/main" id="{B4F612F3-FB94-43FB-BA1F-017620595CE2}"/>
                  </a:ext>
                </a:extLst>
              </p:cNvPr>
              <p:cNvSpPr txBox="1"/>
              <p:nvPr/>
            </p:nvSpPr>
            <p:spPr>
              <a:xfrm>
                <a:off x="9176772" y="1544468"/>
                <a:ext cx="585640" cy="31001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11</a:t>
                </a:r>
                <a:endParaRPr lang="zh-CN" altLang="en-US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4" name="文本框 183">
                <a:extLst>
                  <a:ext uri="{FF2B5EF4-FFF2-40B4-BE49-F238E27FC236}">
                    <a16:creationId xmlns:a16="http://schemas.microsoft.com/office/drawing/2014/main" id="{6BF7AFFB-481F-4A35-99E1-B27DB315155A}"/>
                  </a:ext>
                </a:extLst>
              </p:cNvPr>
              <p:cNvSpPr txBox="1"/>
              <p:nvPr/>
            </p:nvSpPr>
            <p:spPr>
              <a:xfrm>
                <a:off x="9115469" y="522097"/>
                <a:ext cx="646943" cy="31001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375</a:t>
                </a:r>
                <a:endParaRPr lang="zh-CN" altLang="en-US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5" name="组合 4">
              <a:extLst>
                <a:ext uri="{FF2B5EF4-FFF2-40B4-BE49-F238E27FC236}">
                  <a16:creationId xmlns:a16="http://schemas.microsoft.com/office/drawing/2014/main" id="{09A7B0D5-C78E-4D25-A0E8-B52D33CA7F51}"/>
                </a:ext>
              </a:extLst>
            </p:cNvPr>
            <p:cNvGrpSpPr/>
            <p:nvPr/>
          </p:nvGrpSpPr>
          <p:grpSpPr>
            <a:xfrm>
              <a:off x="5560943" y="3292838"/>
              <a:ext cx="3147952" cy="2006096"/>
              <a:chOff x="5560943" y="3292838"/>
              <a:chExt cx="3147952" cy="2006096"/>
            </a:xfrm>
          </p:grpSpPr>
          <p:graphicFrame>
            <p:nvGraphicFramePr>
              <p:cNvPr id="179" name="图表 178">
                <a:extLst>
                  <a:ext uri="{FF2B5EF4-FFF2-40B4-BE49-F238E27FC236}">
                    <a16:creationId xmlns:a16="http://schemas.microsoft.com/office/drawing/2014/main" id="{C242428C-CAAD-4A3A-80B9-AF0A71728EBD}"/>
                  </a:ext>
                </a:extLst>
              </p:cNvPr>
              <p:cNvGraphicFramePr>
                <a:graphicFrameLocks/>
              </p:cNvGraphicFramePr>
              <p:nvPr/>
            </p:nvGraphicFramePr>
            <p:xfrm>
              <a:off x="5776386" y="3292838"/>
              <a:ext cx="2932509" cy="200609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7"/>
              </a:graphicData>
            </a:graphic>
          </p:graphicFrame>
          <p:sp>
            <p:nvSpPr>
              <p:cNvPr id="127" name="文本框 126">
                <a:extLst>
                  <a:ext uri="{FF2B5EF4-FFF2-40B4-BE49-F238E27FC236}">
                    <a16:creationId xmlns:a16="http://schemas.microsoft.com/office/drawing/2014/main" id="{362850DA-A966-4601-8A2D-742B4289DD77}"/>
                  </a:ext>
                </a:extLst>
              </p:cNvPr>
              <p:cNvSpPr txBox="1"/>
              <p:nvPr/>
            </p:nvSpPr>
            <p:spPr>
              <a:xfrm>
                <a:off x="7410726" y="3531197"/>
                <a:ext cx="7963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8" name="文本框 127">
                <a:extLst>
                  <a:ext uri="{FF2B5EF4-FFF2-40B4-BE49-F238E27FC236}">
                    <a16:creationId xmlns:a16="http://schemas.microsoft.com/office/drawing/2014/main" id="{19F60931-2076-4C03-926B-8904BC59D156}"/>
                  </a:ext>
                </a:extLst>
              </p:cNvPr>
              <p:cNvSpPr txBox="1"/>
              <p:nvPr/>
            </p:nvSpPr>
            <p:spPr>
              <a:xfrm>
                <a:off x="7298929" y="4607317"/>
                <a:ext cx="7963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9" name="文本框 128">
                <a:extLst>
                  <a:ext uri="{FF2B5EF4-FFF2-40B4-BE49-F238E27FC236}">
                    <a16:creationId xmlns:a16="http://schemas.microsoft.com/office/drawing/2014/main" id="{05C70946-4256-4F7F-B21F-EA6533EE217F}"/>
                  </a:ext>
                </a:extLst>
              </p:cNvPr>
              <p:cNvSpPr txBox="1"/>
              <p:nvPr/>
            </p:nvSpPr>
            <p:spPr>
              <a:xfrm>
                <a:off x="7155746" y="4623793"/>
                <a:ext cx="7963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" name="文本框 129">
                <a:extLst>
                  <a:ext uri="{FF2B5EF4-FFF2-40B4-BE49-F238E27FC236}">
                    <a16:creationId xmlns:a16="http://schemas.microsoft.com/office/drawing/2014/main" id="{AC39D084-6809-4040-9601-C548B502F01E}"/>
                  </a:ext>
                </a:extLst>
              </p:cNvPr>
              <p:cNvSpPr txBox="1"/>
              <p:nvPr/>
            </p:nvSpPr>
            <p:spPr>
              <a:xfrm>
                <a:off x="7923715" y="4468294"/>
                <a:ext cx="7963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3" name="文本框 132">
                <a:extLst>
                  <a:ext uri="{FF2B5EF4-FFF2-40B4-BE49-F238E27FC236}">
                    <a16:creationId xmlns:a16="http://schemas.microsoft.com/office/drawing/2014/main" id="{1646E69E-900D-4E0D-997E-102D17927063}"/>
                  </a:ext>
                </a:extLst>
              </p:cNvPr>
              <p:cNvSpPr txBox="1"/>
              <p:nvPr/>
            </p:nvSpPr>
            <p:spPr>
              <a:xfrm>
                <a:off x="8444533" y="4268968"/>
                <a:ext cx="7963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4" name="文本框 133">
                <a:extLst>
                  <a:ext uri="{FF2B5EF4-FFF2-40B4-BE49-F238E27FC236}">
                    <a16:creationId xmlns:a16="http://schemas.microsoft.com/office/drawing/2014/main" id="{6E93BEB4-FF55-4FC3-AE07-36BB201BE3EF}"/>
                  </a:ext>
                </a:extLst>
              </p:cNvPr>
              <p:cNvSpPr txBox="1"/>
              <p:nvPr/>
            </p:nvSpPr>
            <p:spPr>
              <a:xfrm>
                <a:off x="8229573" y="4608496"/>
                <a:ext cx="319028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b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5" name="文本框 134">
                <a:extLst>
                  <a:ext uri="{FF2B5EF4-FFF2-40B4-BE49-F238E27FC236}">
                    <a16:creationId xmlns:a16="http://schemas.microsoft.com/office/drawing/2014/main" id="{CDC552D5-DBE1-43F9-AD16-426E456D5549}"/>
                  </a:ext>
                </a:extLst>
              </p:cNvPr>
              <p:cNvSpPr txBox="1"/>
              <p:nvPr/>
            </p:nvSpPr>
            <p:spPr>
              <a:xfrm>
                <a:off x="8204687" y="4619642"/>
                <a:ext cx="7963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6" name="文本框 135">
                <a:extLst>
                  <a:ext uri="{FF2B5EF4-FFF2-40B4-BE49-F238E27FC236}">
                    <a16:creationId xmlns:a16="http://schemas.microsoft.com/office/drawing/2014/main" id="{892A932C-DD3E-412F-9E68-39AB30CB71DA}"/>
                  </a:ext>
                </a:extLst>
              </p:cNvPr>
              <p:cNvSpPr txBox="1"/>
              <p:nvPr/>
            </p:nvSpPr>
            <p:spPr>
              <a:xfrm>
                <a:off x="6364934" y="4616522"/>
                <a:ext cx="7963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7" name="文本框 136">
                <a:extLst>
                  <a:ext uri="{FF2B5EF4-FFF2-40B4-BE49-F238E27FC236}">
                    <a16:creationId xmlns:a16="http://schemas.microsoft.com/office/drawing/2014/main" id="{9927A173-D5CB-41A2-9482-9265368E3BDC}"/>
                  </a:ext>
                </a:extLst>
              </p:cNvPr>
              <p:cNvSpPr txBox="1"/>
              <p:nvPr/>
            </p:nvSpPr>
            <p:spPr>
              <a:xfrm>
                <a:off x="6246849" y="4454909"/>
                <a:ext cx="7963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9" name="文本框 138">
                <a:extLst>
                  <a:ext uri="{FF2B5EF4-FFF2-40B4-BE49-F238E27FC236}">
                    <a16:creationId xmlns:a16="http://schemas.microsoft.com/office/drawing/2014/main" id="{1915A8BB-7DD7-4835-99D9-C34FE1F99081}"/>
                  </a:ext>
                </a:extLst>
              </p:cNvPr>
              <p:cNvSpPr txBox="1"/>
              <p:nvPr/>
            </p:nvSpPr>
            <p:spPr>
              <a:xfrm>
                <a:off x="6872964" y="4417641"/>
                <a:ext cx="7963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0" name="文本框 139">
                <a:extLst>
                  <a:ext uri="{FF2B5EF4-FFF2-40B4-BE49-F238E27FC236}">
                    <a16:creationId xmlns:a16="http://schemas.microsoft.com/office/drawing/2014/main" id="{2A23B32D-5F06-4EF1-9CEE-5F0270A12090}"/>
                  </a:ext>
                </a:extLst>
              </p:cNvPr>
              <p:cNvSpPr txBox="1"/>
              <p:nvPr/>
            </p:nvSpPr>
            <p:spPr>
              <a:xfrm>
                <a:off x="6777615" y="4661848"/>
                <a:ext cx="49167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1" name="文本框 140">
                <a:extLst>
                  <a:ext uri="{FF2B5EF4-FFF2-40B4-BE49-F238E27FC236}">
                    <a16:creationId xmlns:a16="http://schemas.microsoft.com/office/drawing/2014/main" id="{0C8012E5-93E7-441E-AAD6-C90C0A4CB51D}"/>
                  </a:ext>
                </a:extLst>
              </p:cNvPr>
              <p:cNvSpPr txBox="1"/>
              <p:nvPr/>
            </p:nvSpPr>
            <p:spPr>
              <a:xfrm>
                <a:off x="6637581" y="4661848"/>
                <a:ext cx="7963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b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4" name="文本框 163">
                <a:extLst>
                  <a:ext uri="{FF2B5EF4-FFF2-40B4-BE49-F238E27FC236}">
                    <a16:creationId xmlns:a16="http://schemas.microsoft.com/office/drawing/2014/main" id="{281B8FDD-458A-4CB1-84A9-2E8112C345F2}"/>
                  </a:ext>
                </a:extLst>
              </p:cNvPr>
              <p:cNvSpPr txBox="1"/>
              <p:nvPr/>
            </p:nvSpPr>
            <p:spPr>
              <a:xfrm>
                <a:off x="7820426" y="4566477"/>
                <a:ext cx="7963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5" name="文本框 164">
                <a:extLst>
                  <a:ext uri="{FF2B5EF4-FFF2-40B4-BE49-F238E27FC236}">
                    <a16:creationId xmlns:a16="http://schemas.microsoft.com/office/drawing/2014/main" id="{4EC5013A-5C66-4DAB-BB8B-205484939831}"/>
                  </a:ext>
                </a:extLst>
              </p:cNvPr>
              <p:cNvSpPr txBox="1"/>
              <p:nvPr/>
            </p:nvSpPr>
            <p:spPr>
              <a:xfrm>
                <a:off x="7681595" y="4628167"/>
                <a:ext cx="7963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0" name="文本框 169">
                <a:extLst>
                  <a:ext uri="{FF2B5EF4-FFF2-40B4-BE49-F238E27FC236}">
                    <a16:creationId xmlns:a16="http://schemas.microsoft.com/office/drawing/2014/main" id="{B60A07A3-5147-41DD-8A58-ACFF41DD295C}"/>
                  </a:ext>
                </a:extLst>
              </p:cNvPr>
              <p:cNvSpPr txBox="1"/>
              <p:nvPr/>
            </p:nvSpPr>
            <p:spPr>
              <a:xfrm>
                <a:off x="6126462" y="4515255"/>
                <a:ext cx="7963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" name="文本框 8">
                <a:extLst>
                  <a:ext uri="{FF2B5EF4-FFF2-40B4-BE49-F238E27FC236}">
                    <a16:creationId xmlns:a16="http://schemas.microsoft.com/office/drawing/2014/main" id="{1400F1DE-CBF3-4118-ADEC-AE67666E3B97}"/>
                  </a:ext>
                </a:extLst>
              </p:cNvPr>
              <p:cNvSpPr txBox="1"/>
              <p:nvPr/>
            </p:nvSpPr>
            <p:spPr>
              <a:xfrm rot="16200000">
                <a:off x="5371743" y="4026961"/>
                <a:ext cx="59384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uc/Ren</a:t>
                </a:r>
                <a:endParaRPr lang="zh-CN" altLang="en-US" sz="8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4" name="组合 13">
              <a:extLst>
                <a:ext uri="{FF2B5EF4-FFF2-40B4-BE49-F238E27FC236}">
                  <a16:creationId xmlns:a16="http://schemas.microsoft.com/office/drawing/2014/main" id="{6358188C-48DA-4759-BDFA-5D02472A3391}"/>
                </a:ext>
              </a:extLst>
            </p:cNvPr>
            <p:cNvGrpSpPr/>
            <p:nvPr/>
          </p:nvGrpSpPr>
          <p:grpSpPr>
            <a:xfrm>
              <a:off x="5675554" y="2419920"/>
              <a:ext cx="1080868" cy="903464"/>
              <a:chOff x="9599197" y="516823"/>
              <a:chExt cx="1676654" cy="1311798"/>
            </a:xfrm>
          </p:grpSpPr>
          <p:grpSp>
            <p:nvGrpSpPr>
              <p:cNvPr id="94" name="组合 93">
                <a:extLst>
                  <a:ext uri="{FF2B5EF4-FFF2-40B4-BE49-F238E27FC236}">
                    <a16:creationId xmlns:a16="http://schemas.microsoft.com/office/drawing/2014/main" id="{7612CAA9-C89F-4778-9AA5-0CA9A3A91700}"/>
                  </a:ext>
                </a:extLst>
              </p:cNvPr>
              <p:cNvGrpSpPr/>
              <p:nvPr/>
            </p:nvGrpSpPr>
            <p:grpSpPr>
              <a:xfrm>
                <a:off x="9599197" y="516823"/>
                <a:ext cx="1676654" cy="1311798"/>
                <a:chOff x="6514377" y="1736184"/>
                <a:chExt cx="1676654" cy="1311798"/>
              </a:xfrm>
            </p:grpSpPr>
            <p:pic>
              <p:nvPicPr>
                <p:cNvPr id="38" name="图片 37">
                  <a:extLst>
                    <a:ext uri="{FF2B5EF4-FFF2-40B4-BE49-F238E27FC236}">
                      <a16:creationId xmlns:a16="http://schemas.microsoft.com/office/drawing/2014/main" id="{740B065C-5429-4D3D-AC22-BC7750C8EFE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7182" t="23631" r="15169" b="16468"/>
                <a:stretch/>
              </p:blipFill>
              <p:spPr>
                <a:xfrm>
                  <a:off x="6514377" y="1825030"/>
                  <a:ext cx="1142714" cy="1172084"/>
                </a:xfrm>
                <a:prstGeom prst="rect">
                  <a:avLst/>
                </a:prstGeom>
              </p:spPr>
            </p:pic>
            <p:sp>
              <p:nvSpPr>
                <p:cNvPr id="185" name="矩形 184">
                  <a:extLst>
                    <a:ext uri="{FF2B5EF4-FFF2-40B4-BE49-F238E27FC236}">
                      <a16:creationId xmlns:a16="http://schemas.microsoft.com/office/drawing/2014/main" id="{89AC3698-3663-497C-B67D-6C213F090617}"/>
                    </a:ext>
                  </a:extLst>
                </p:cNvPr>
                <p:cNvSpPr/>
                <p:nvPr/>
              </p:nvSpPr>
              <p:spPr>
                <a:xfrm>
                  <a:off x="7655109" y="1825030"/>
                  <a:ext cx="224054" cy="1172986"/>
                </a:xfrm>
                <a:prstGeom prst="rect">
                  <a:avLst/>
                </a:prstGeom>
                <a:solidFill>
                  <a:schemeClr val="tx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/>
                </a:p>
              </p:txBody>
            </p:sp>
            <p:sp>
              <p:nvSpPr>
                <p:cNvPr id="186" name="矩形 185">
                  <a:extLst>
                    <a:ext uri="{FF2B5EF4-FFF2-40B4-BE49-F238E27FC236}">
                      <a16:creationId xmlns:a16="http://schemas.microsoft.com/office/drawing/2014/main" id="{BC4CB6A1-0C26-4C70-9109-44DA2CEFC0EB}"/>
                    </a:ext>
                  </a:extLst>
                </p:cNvPr>
                <p:cNvSpPr/>
                <p:nvPr/>
              </p:nvSpPr>
              <p:spPr>
                <a:xfrm>
                  <a:off x="7699831" y="1926737"/>
                  <a:ext cx="94040" cy="946509"/>
                </a:xfrm>
                <a:prstGeom prst="rect">
                  <a:avLst/>
                </a:prstGeom>
                <a:gradFill>
                  <a:gsLst>
                    <a:gs pos="0">
                      <a:srgbClr val="FF0900"/>
                    </a:gs>
                    <a:gs pos="31471">
                      <a:srgbClr val="FFFF00"/>
                    </a:gs>
                    <a:gs pos="22000">
                      <a:srgbClr val="FFEC00"/>
                    </a:gs>
                    <a:gs pos="65000">
                      <a:srgbClr val="00F3FF"/>
                    </a:gs>
                    <a:gs pos="84000">
                      <a:srgbClr val="0000E0"/>
                    </a:gs>
                    <a:gs pos="47188">
                      <a:srgbClr val="00FF29"/>
                    </a:gs>
                    <a:gs pos="100000">
                      <a:schemeClr val="tx1"/>
                    </a:gs>
                  </a:gsLst>
                  <a:lin ang="5400000" scaled="0"/>
                </a:gra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zh-CN" altLang="en-US" sz="800"/>
                </a:p>
              </p:txBody>
            </p:sp>
            <p:sp>
              <p:nvSpPr>
                <p:cNvPr id="187" name="文本框 186">
                  <a:extLst>
                    <a:ext uri="{FF2B5EF4-FFF2-40B4-BE49-F238E27FC236}">
                      <a16:creationId xmlns:a16="http://schemas.microsoft.com/office/drawing/2014/main" id="{DBFD8FEC-80EF-4C1E-AB38-45602A4C5ABA}"/>
                    </a:ext>
                  </a:extLst>
                </p:cNvPr>
                <p:cNvSpPr txBox="1"/>
                <p:nvPr/>
              </p:nvSpPr>
              <p:spPr>
                <a:xfrm>
                  <a:off x="7423413" y="2735165"/>
                  <a:ext cx="767618" cy="31281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411</a:t>
                  </a:r>
                  <a:endParaRPr lang="zh-CN" altLang="en-US" sz="8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8" name="文本框 187">
                  <a:extLst>
                    <a:ext uri="{FF2B5EF4-FFF2-40B4-BE49-F238E27FC236}">
                      <a16:creationId xmlns:a16="http://schemas.microsoft.com/office/drawing/2014/main" id="{9147D366-1E49-444A-8098-7FF0555F0F9D}"/>
                    </a:ext>
                  </a:extLst>
                </p:cNvPr>
                <p:cNvSpPr txBox="1"/>
                <p:nvPr/>
              </p:nvSpPr>
              <p:spPr>
                <a:xfrm>
                  <a:off x="7397508" y="1736184"/>
                  <a:ext cx="632992" cy="31281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535</a:t>
                  </a:r>
                  <a:endParaRPr lang="zh-CN" altLang="en-US" sz="8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71" name="文本框 170">
                <a:extLst>
                  <a:ext uri="{FF2B5EF4-FFF2-40B4-BE49-F238E27FC236}">
                    <a16:creationId xmlns:a16="http://schemas.microsoft.com/office/drawing/2014/main" id="{066FF465-5056-4DD9-A02F-1C79AE0C6921}"/>
                  </a:ext>
                </a:extLst>
              </p:cNvPr>
              <p:cNvSpPr txBox="1"/>
              <p:nvPr/>
            </p:nvSpPr>
            <p:spPr>
              <a:xfrm>
                <a:off x="9856720" y="1510950"/>
                <a:ext cx="944794" cy="31281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AR2Pro</a:t>
                </a:r>
                <a:endParaRPr lang="zh-CN" altLang="en-US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6" name="组合 15">
              <a:extLst>
                <a:ext uri="{FF2B5EF4-FFF2-40B4-BE49-F238E27FC236}">
                  <a16:creationId xmlns:a16="http://schemas.microsoft.com/office/drawing/2014/main" id="{AA3F692A-DDBC-42EA-888F-17C94C0E1643}"/>
                </a:ext>
              </a:extLst>
            </p:cNvPr>
            <p:cNvGrpSpPr/>
            <p:nvPr/>
          </p:nvGrpSpPr>
          <p:grpSpPr>
            <a:xfrm>
              <a:off x="6633142" y="2414735"/>
              <a:ext cx="1061046" cy="929290"/>
              <a:chOff x="6899327" y="1793068"/>
              <a:chExt cx="1547139" cy="1355022"/>
            </a:xfrm>
          </p:grpSpPr>
          <p:grpSp>
            <p:nvGrpSpPr>
              <p:cNvPr id="95" name="组合 94">
                <a:extLst>
                  <a:ext uri="{FF2B5EF4-FFF2-40B4-BE49-F238E27FC236}">
                    <a16:creationId xmlns:a16="http://schemas.microsoft.com/office/drawing/2014/main" id="{F555794D-B322-4306-89A7-A901EE03B0F3}"/>
                  </a:ext>
                </a:extLst>
              </p:cNvPr>
              <p:cNvGrpSpPr/>
              <p:nvPr/>
            </p:nvGrpSpPr>
            <p:grpSpPr>
              <a:xfrm>
                <a:off x="6899327" y="1793068"/>
                <a:ext cx="1547139" cy="1355022"/>
                <a:chOff x="7908932" y="1725354"/>
                <a:chExt cx="1547139" cy="1355022"/>
              </a:xfrm>
            </p:grpSpPr>
            <p:sp>
              <p:nvSpPr>
                <p:cNvPr id="166" name="文本框 165">
                  <a:extLst>
                    <a:ext uri="{FF2B5EF4-FFF2-40B4-BE49-F238E27FC236}">
                      <a16:creationId xmlns:a16="http://schemas.microsoft.com/office/drawing/2014/main" id="{5B670E31-105F-4AEA-9342-7A190B163A20}"/>
                    </a:ext>
                  </a:extLst>
                </p:cNvPr>
                <p:cNvSpPr txBox="1"/>
                <p:nvPr/>
              </p:nvSpPr>
              <p:spPr>
                <a:xfrm>
                  <a:off x="8204940" y="2745622"/>
                  <a:ext cx="1178147" cy="3141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NS1Pro</a:t>
                  </a:r>
                  <a:endParaRPr lang="zh-CN" altLang="en-US" sz="8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93" name="组合 92">
                  <a:extLst>
                    <a:ext uri="{FF2B5EF4-FFF2-40B4-BE49-F238E27FC236}">
                      <a16:creationId xmlns:a16="http://schemas.microsoft.com/office/drawing/2014/main" id="{9E7FEB25-E5D0-4DB6-A3F0-40127026FE03}"/>
                    </a:ext>
                  </a:extLst>
                </p:cNvPr>
                <p:cNvGrpSpPr/>
                <p:nvPr/>
              </p:nvGrpSpPr>
              <p:grpSpPr>
                <a:xfrm>
                  <a:off x="7908932" y="1822559"/>
                  <a:ext cx="1361708" cy="1178754"/>
                  <a:chOff x="7908932" y="1822559"/>
                  <a:chExt cx="1361708" cy="1178754"/>
                </a:xfrm>
              </p:grpSpPr>
              <p:pic>
                <p:nvPicPr>
                  <p:cNvPr id="28" name="图片 27">
                    <a:extLst>
                      <a:ext uri="{FF2B5EF4-FFF2-40B4-BE49-F238E27FC236}">
                        <a16:creationId xmlns:a16="http://schemas.microsoft.com/office/drawing/2014/main" id="{61EAAACB-4985-41D1-917B-D835CAF855A6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19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44112" t="21604" r="14821" b="15642"/>
                  <a:stretch/>
                </p:blipFill>
                <p:spPr>
                  <a:xfrm>
                    <a:off x="7908932" y="1825030"/>
                    <a:ext cx="1151715" cy="1176283"/>
                  </a:xfrm>
                  <a:prstGeom prst="rect">
                    <a:avLst/>
                  </a:prstGeom>
                </p:spPr>
              </p:pic>
              <p:sp>
                <p:nvSpPr>
                  <p:cNvPr id="189" name="矩形 188">
                    <a:extLst>
                      <a:ext uri="{FF2B5EF4-FFF2-40B4-BE49-F238E27FC236}">
                        <a16:creationId xmlns:a16="http://schemas.microsoft.com/office/drawing/2014/main" id="{CDD368D8-AEBE-4F91-96CB-B299A156DA31}"/>
                      </a:ext>
                    </a:extLst>
                  </p:cNvPr>
                  <p:cNvSpPr/>
                  <p:nvPr/>
                </p:nvSpPr>
                <p:spPr>
                  <a:xfrm>
                    <a:off x="9060647" y="1822559"/>
                    <a:ext cx="209993" cy="1177543"/>
                  </a:xfrm>
                  <a:prstGeom prst="rect">
                    <a:avLst/>
                  </a:prstGeom>
                  <a:solidFill>
                    <a:schemeClr val="tx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800"/>
                  </a:p>
                </p:txBody>
              </p:sp>
              <p:sp>
                <p:nvSpPr>
                  <p:cNvPr id="190" name="矩形 189">
                    <a:extLst>
                      <a:ext uri="{FF2B5EF4-FFF2-40B4-BE49-F238E27FC236}">
                        <a16:creationId xmlns:a16="http://schemas.microsoft.com/office/drawing/2014/main" id="{97EBD913-CA52-4C4F-8C47-155DAB633EC8}"/>
                      </a:ext>
                    </a:extLst>
                  </p:cNvPr>
                  <p:cNvSpPr/>
                  <p:nvPr/>
                </p:nvSpPr>
                <p:spPr>
                  <a:xfrm>
                    <a:off x="9105368" y="1935988"/>
                    <a:ext cx="94040" cy="946509"/>
                  </a:xfrm>
                  <a:prstGeom prst="rect">
                    <a:avLst/>
                  </a:prstGeom>
                  <a:gradFill>
                    <a:gsLst>
                      <a:gs pos="0">
                        <a:srgbClr val="FF0900"/>
                      </a:gs>
                      <a:gs pos="31471">
                        <a:srgbClr val="FFFF00"/>
                      </a:gs>
                      <a:gs pos="22000">
                        <a:srgbClr val="FFEC00"/>
                      </a:gs>
                      <a:gs pos="65000">
                        <a:srgbClr val="00F3FF"/>
                      </a:gs>
                      <a:gs pos="84000">
                        <a:srgbClr val="0000E0"/>
                      </a:gs>
                      <a:gs pos="47188">
                        <a:srgbClr val="00FF29"/>
                      </a:gs>
                      <a:gs pos="100000">
                        <a:schemeClr val="tx1"/>
                      </a:gs>
                    </a:gsLst>
                    <a:lin ang="5400000" scaled="0"/>
                  </a:gra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zh-CN" altLang="en-US" sz="800"/>
                  </a:p>
                </p:txBody>
              </p:sp>
            </p:grpSp>
            <p:sp>
              <p:nvSpPr>
                <p:cNvPr id="191" name="文本框 190">
                  <a:extLst>
                    <a:ext uri="{FF2B5EF4-FFF2-40B4-BE49-F238E27FC236}">
                      <a16:creationId xmlns:a16="http://schemas.microsoft.com/office/drawing/2014/main" id="{2929C76F-0BE4-4E44-8BC6-E07628759534}"/>
                    </a:ext>
                  </a:extLst>
                </p:cNvPr>
                <p:cNvSpPr txBox="1"/>
                <p:nvPr/>
              </p:nvSpPr>
              <p:spPr>
                <a:xfrm>
                  <a:off x="8837834" y="2766232"/>
                  <a:ext cx="592635" cy="3141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411</a:t>
                  </a:r>
                  <a:endParaRPr lang="zh-CN" altLang="en-US" sz="8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92" name="文本框 191">
                  <a:extLst>
                    <a:ext uri="{FF2B5EF4-FFF2-40B4-BE49-F238E27FC236}">
                      <a16:creationId xmlns:a16="http://schemas.microsoft.com/office/drawing/2014/main" id="{ECAE5F83-3398-4C56-9CF8-56614A723F77}"/>
                    </a:ext>
                  </a:extLst>
                </p:cNvPr>
                <p:cNvSpPr txBox="1"/>
                <p:nvPr/>
              </p:nvSpPr>
              <p:spPr>
                <a:xfrm>
                  <a:off x="8848706" y="1725354"/>
                  <a:ext cx="607365" cy="314145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zh-CN" sz="800" dirty="0">
                      <a:solidFill>
                        <a:schemeClr val="bg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303</a:t>
                  </a:r>
                  <a:endParaRPr lang="zh-CN" altLang="en-US" sz="8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172" name="文本框 171">
                <a:extLst>
                  <a:ext uri="{FF2B5EF4-FFF2-40B4-BE49-F238E27FC236}">
                    <a16:creationId xmlns:a16="http://schemas.microsoft.com/office/drawing/2014/main" id="{08A8D95E-D095-42DE-B3A0-DC492BEC3C4E}"/>
                  </a:ext>
                </a:extLst>
              </p:cNvPr>
              <p:cNvSpPr txBox="1"/>
              <p:nvPr/>
            </p:nvSpPr>
            <p:spPr>
              <a:xfrm>
                <a:off x="7205883" y="2781369"/>
                <a:ext cx="910933" cy="3141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NS1Pro</a:t>
                </a:r>
                <a:endParaRPr lang="zh-CN" altLang="en-US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2" name="组合 11">
              <a:extLst>
                <a:ext uri="{FF2B5EF4-FFF2-40B4-BE49-F238E27FC236}">
                  <a16:creationId xmlns:a16="http://schemas.microsoft.com/office/drawing/2014/main" id="{B331F7C5-287E-4C36-B9A2-CEC539158CA3}"/>
                </a:ext>
              </a:extLst>
            </p:cNvPr>
            <p:cNvGrpSpPr/>
            <p:nvPr/>
          </p:nvGrpSpPr>
          <p:grpSpPr>
            <a:xfrm>
              <a:off x="6622421" y="1431841"/>
              <a:ext cx="1031228" cy="916237"/>
              <a:chOff x="6880604" y="520119"/>
              <a:chExt cx="1512268" cy="1335990"/>
            </a:xfrm>
          </p:grpSpPr>
          <p:pic>
            <p:nvPicPr>
              <p:cNvPr id="11" name="图片 10">
                <a:extLst>
                  <a:ext uri="{FF2B5EF4-FFF2-40B4-BE49-F238E27FC236}">
                    <a16:creationId xmlns:a16="http://schemas.microsoft.com/office/drawing/2014/main" id="{C1C374A6-3F64-40C2-8857-7C9AFA1FB87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9759" t="36720" r="35677" b="13390"/>
              <a:stretch/>
            </p:blipFill>
            <p:spPr>
              <a:xfrm>
                <a:off x="6880604" y="618369"/>
                <a:ext cx="1140200" cy="1159200"/>
              </a:xfrm>
              <a:prstGeom prst="rect">
                <a:avLst/>
              </a:prstGeom>
            </p:spPr>
          </p:pic>
          <p:sp>
            <p:nvSpPr>
              <p:cNvPr id="108" name="文本框 107">
                <a:extLst>
                  <a:ext uri="{FF2B5EF4-FFF2-40B4-BE49-F238E27FC236}">
                    <a16:creationId xmlns:a16="http://schemas.microsoft.com/office/drawing/2014/main" id="{03F750DD-4E92-4734-9ABE-E5B778078CB4}"/>
                  </a:ext>
                </a:extLst>
              </p:cNvPr>
              <p:cNvSpPr txBox="1"/>
              <p:nvPr/>
            </p:nvSpPr>
            <p:spPr>
              <a:xfrm>
                <a:off x="7174604" y="1480623"/>
                <a:ext cx="1178147" cy="3141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NR2Pro</a:t>
                </a:r>
                <a:endParaRPr lang="zh-CN" altLang="en-US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7" name="矩形 176">
                <a:extLst>
                  <a:ext uri="{FF2B5EF4-FFF2-40B4-BE49-F238E27FC236}">
                    <a16:creationId xmlns:a16="http://schemas.microsoft.com/office/drawing/2014/main" id="{D3167ED8-F9EA-4719-9DEB-7AC842AEDCA6}"/>
                  </a:ext>
                </a:extLst>
              </p:cNvPr>
              <p:cNvSpPr/>
              <p:nvPr/>
            </p:nvSpPr>
            <p:spPr>
              <a:xfrm>
                <a:off x="8021683" y="618370"/>
                <a:ext cx="209993" cy="1158521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/>
              </a:p>
            </p:txBody>
          </p:sp>
          <p:sp>
            <p:nvSpPr>
              <p:cNvPr id="178" name="矩形 177">
                <a:extLst>
                  <a:ext uri="{FF2B5EF4-FFF2-40B4-BE49-F238E27FC236}">
                    <a16:creationId xmlns:a16="http://schemas.microsoft.com/office/drawing/2014/main" id="{D3B19807-7187-4C57-8BFA-74D250ADAC47}"/>
                  </a:ext>
                </a:extLst>
              </p:cNvPr>
              <p:cNvSpPr/>
              <p:nvPr/>
            </p:nvSpPr>
            <p:spPr>
              <a:xfrm>
                <a:off x="8066631" y="720934"/>
                <a:ext cx="94040" cy="946509"/>
              </a:xfrm>
              <a:prstGeom prst="rect">
                <a:avLst/>
              </a:prstGeom>
              <a:gradFill>
                <a:gsLst>
                  <a:gs pos="0">
                    <a:srgbClr val="FF0900"/>
                  </a:gs>
                  <a:gs pos="31471">
                    <a:srgbClr val="FFFF00"/>
                  </a:gs>
                  <a:gs pos="22000">
                    <a:srgbClr val="FFEC00"/>
                  </a:gs>
                  <a:gs pos="65000">
                    <a:srgbClr val="00F3FF"/>
                  </a:gs>
                  <a:gs pos="84000">
                    <a:srgbClr val="0000E0"/>
                  </a:gs>
                  <a:gs pos="47188">
                    <a:srgbClr val="00FF29"/>
                  </a:gs>
                  <a:gs pos="100000">
                    <a:schemeClr val="tx1"/>
                  </a:gs>
                </a:gsLst>
                <a:lin ang="5400000" scaled="0"/>
              </a:gra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zh-CN" altLang="en-US" sz="800"/>
              </a:p>
            </p:txBody>
          </p:sp>
          <p:sp>
            <p:nvSpPr>
              <p:cNvPr id="180" name="文本框 179">
                <a:extLst>
                  <a:ext uri="{FF2B5EF4-FFF2-40B4-BE49-F238E27FC236}">
                    <a16:creationId xmlns:a16="http://schemas.microsoft.com/office/drawing/2014/main" id="{7E9EE200-12E3-4B78-9975-781F6A14CD35}"/>
                  </a:ext>
                </a:extLst>
              </p:cNvPr>
              <p:cNvSpPr txBox="1"/>
              <p:nvPr/>
            </p:nvSpPr>
            <p:spPr>
              <a:xfrm>
                <a:off x="7781420" y="520119"/>
                <a:ext cx="600153" cy="3141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047</a:t>
                </a:r>
                <a:endParaRPr lang="zh-CN" altLang="en-US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3" name="文本框 172">
                <a:extLst>
                  <a:ext uri="{FF2B5EF4-FFF2-40B4-BE49-F238E27FC236}">
                    <a16:creationId xmlns:a16="http://schemas.microsoft.com/office/drawing/2014/main" id="{B075B00A-9BEF-4E2D-A26D-E42F95A92B0A}"/>
                  </a:ext>
                </a:extLst>
              </p:cNvPr>
              <p:cNvSpPr txBox="1"/>
              <p:nvPr/>
            </p:nvSpPr>
            <p:spPr>
              <a:xfrm>
                <a:off x="7770576" y="1541964"/>
                <a:ext cx="622296" cy="31414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zh-CN" sz="800" dirty="0">
                    <a:solidFill>
                      <a:schemeClr val="bg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411</a:t>
                </a:r>
                <a:endParaRPr lang="zh-CN" altLang="en-US" sz="800" dirty="0">
                  <a:solidFill>
                    <a:schemeClr val="bg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cxnSp>
          <p:nvCxnSpPr>
            <p:cNvPr id="160" name="Straight Connector 50">
              <a:extLst>
                <a:ext uri="{FF2B5EF4-FFF2-40B4-BE49-F238E27FC236}">
                  <a16:creationId xmlns:a16="http://schemas.microsoft.com/office/drawing/2014/main" id="{E1943D55-F476-43D9-AE02-C54FA2B07E1A}"/>
                </a:ext>
              </a:extLst>
            </p:cNvPr>
            <p:cNvCxnSpPr>
              <a:cxnSpLocks/>
            </p:cNvCxnSpPr>
            <p:nvPr/>
          </p:nvCxnSpPr>
          <p:spPr>
            <a:xfrm>
              <a:off x="3597307" y="1605659"/>
              <a:ext cx="916096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1" name="Straight Connector 50">
              <a:extLst>
                <a:ext uri="{FF2B5EF4-FFF2-40B4-BE49-F238E27FC236}">
                  <a16:creationId xmlns:a16="http://schemas.microsoft.com/office/drawing/2014/main" id="{EF685232-569C-4A70-ABAD-A6EF814C78E3}"/>
                </a:ext>
              </a:extLst>
            </p:cNvPr>
            <p:cNvCxnSpPr>
              <a:cxnSpLocks/>
            </p:cNvCxnSpPr>
            <p:nvPr/>
          </p:nvCxnSpPr>
          <p:spPr>
            <a:xfrm>
              <a:off x="2459472" y="1605659"/>
              <a:ext cx="964114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21531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</TotalTime>
  <Words>114</Words>
  <Application>Microsoft Office PowerPoint</Application>
  <PresentationFormat>宽屏</PresentationFormat>
  <Paragraphs>70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亚荣</dc:creator>
  <cp:lastModifiedBy>王 亚荣</cp:lastModifiedBy>
  <cp:revision>15</cp:revision>
  <dcterms:created xsi:type="dcterms:W3CDTF">2025-04-18T01:16:52Z</dcterms:created>
  <dcterms:modified xsi:type="dcterms:W3CDTF">2025-04-18T01:54:59Z</dcterms:modified>
</cp:coreProperties>
</file>